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7" r:id="rId2"/>
  </p:sldIdLst>
  <p:sldSz cx="9144000" cy="6858000" type="screen4x3"/>
  <p:notesSz cx="6802438" cy="99345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QC-AF" initials="AF" lastIdx="2" clrIdx="0"/>
  <p:cmAuthor id="1" name="YAMAKAWA SATORU / 山川 悟" initials="YS/山悟" lastIdx="1" clrIdx="1">
    <p:extLst/>
  </p:cmAuthor>
  <p:cmAuthor id="2" name="James Graham" initials="JG" lastIdx="1" clrIdx="2">
    <p:extLst/>
  </p:cmAuthor>
  <p:cmAuthor id="3" name="Ni Ni Moe Myint" initials="NNMM" lastIdx="1" clrIdx="3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F7F7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8019" autoAdjust="0"/>
    <p:restoredTop sz="81692" autoAdjust="0"/>
  </p:normalViewPr>
  <p:slideViewPr>
    <p:cSldViewPr snapToGrid="0">
      <p:cViewPr varScale="1">
        <p:scale>
          <a:sx n="112" d="100"/>
          <a:sy n="112" d="100"/>
        </p:scale>
        <p:origin x="-1962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6/11/relationships/changesInfo" Target="changesInfos/changesInfo1.xml"/><Relationship Id="rId4" Type="http://schemas.openxmlformats.org/officeDocument/2006/relationships/commentAuthors" Target="commentAuthor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ika, Tomoya (EMC)" userId="38927815-4abc-4ee6-9bbe-be8bb685ce77" providerId="ADAL" clId="{7408F830-9E19-4D6D-A3BE-87A817EE8764}"/>
    <pc:docChg chg="undo custSel addSld modSld">
      <pc:chgData name="Saika, Tomoya (EMC)" userId="38927815-4abc-4ee6-9bbe-be8bb685ce77" providerId="ADAL" clId="{7408F830-9E19-4D6D-A3BE-87A817EE8764}" dt="2018-09-25T06:57:35.838" v="568" actId="14100"/>
      <pc:docMkLst>
        <pc:docMk/>
      </pc:docMkLst>
      <pc:sldChg chg="modSp">
        <pc:chgData name="Saika, Tomoya (EMC)" userId="38927815-4abc-4ee6-9bbe-be8bb685ce77" providerId="ADAL" clId="{7408F830-9E19-4D6D-A3BE-87A817EE8764}" dt="2018-09-25T06:31:06.533" v="88" actId="20577"/>
        <pc:sldMkLst>
          <pc:docMk/>
          <pc:sldMk cId="2864764592" sldId="258"/>
        </pc:sldMkLst>
        <pc:spChg chg="mod">
          <ac:chgData name="Saika, Tomoya (EMC)" userId="38927815-4abc-4ee6-9bbe-be8bb685ce77" providerId="ADAL" clId="{7408F830-9E19-4D6D-A3BE-87A817EE8764}" dt="2018-09-25T06:31:06.533" v="88" actId="20577"/>
          <ac:spMkLst>
            <pc:docMk/>
            <pc:sldMk cId="2864764592" sldId="258"/>
            <ac:spMk id="3" creationId="{F3808398-3FE6-460D-980A-2CA8EA9C54F4}"/>
          </ac:spMkLst>
        </pc:spChg>
      </pc:sldChg>
      <pc:sldChg chg="addSp delSp modSp">
        <pc:chgData name="Saika, Tomoya (EMC)" userId="38927815-4abc-4ee6-9bbe-be8bb685ce77" providerId="ADAL" clId="{7408F830-9E19-4D6D-A3BE-87A817EE8764}" dt="2018-09-25T06:29:12.133" v="36" actId="20577"/>
        <pc:sldMkLst>
          <pc:docMk/>
          <pc:sldMk cId="297536780" sldId="260"/>
        </pc:sldMkLst>
        <pc:spChg chg="add del mod">
          <ac:chgData name="Saika, Tomoya (EMC)" userId="38927815-4abc-4ee6-9bbe-be8bb685ce77" providerId="ADAL" clId="{7408F830-9E19-4D6D-A3BE-87A817EE8764}" dt="2018-09-25T06:29:12.133" v="36" actId="20577"/>
          <ac:spMkLst>
            <pc:docMk/>
            <pc:sldMk cId="297536780" sldId="260"/>
            <ac:spMk id="7" creationId="{1A3B5EE3-2EF0-4069-BF93-D82E0B73F23C}"/>
          </ac:spMkLst>
        </pc:spChg>
      </pc:sldChg>
      <pc:sldChg chg="modSp">
        <pc:chgData name="Saika, Tomoya (EMC)" userId="38927815-4abc-4ee6-9bbe-be8bb685ce77" providerId="ADAL" clId="{7408F830-9E19-4D6D-A3BE-87A817EE8764}" dt="2018-09-25T06:29:29.791" v="41" actId="20577"/>
        <pc:sldMkLst>
          <pc:docMk/>
          <pc:sldMk cId="3811333451" sldId="261"/>
        </pc:sldMkLst>
        <pc:spChg chg="mod">
          <ac:chgData name="Saika, Tomoya (EMC)" userId="38927815-4abc-4ee6-9bbe-be8bb685ce77" providerId="ADAL" clId="{7408F830-9E19-4D6D-A3BE-87A817EE8764}" dt="2018-09-25T06:29:29.791" v="41" actId="20577"/>
          <ac:spMkLst>
            <pc:docMk/>
            <pc:sldMk cId="3811333451" sldId="261"/>
            <ac:spMk id="28" creationId="{56691F0D-927F-43BB-9E9A-0BDFD9054097}"/>
          </ac:spMkLst>
        </pc:spChg>
      </pc:sldChg>
      <pc:sldChg chg="addSp modSp">
        <pc:chgData name="Saika, Tomoya (EMC)" userId="38927815-4abc-4ee6-9bbe-be8bb685ce77" providerId="ADAL" clId="{7408F830-9E19-4D6D-A3BE-87A817EE8764}" dt="2018-09-25T06:57:35.838" v="568" actId="14100"/>
        <pc:sldMkLst>
          <pc:docMk/>
          <pc:sldMk cId="2250013806" sldId="262"/>
        </pc:sldMkLst>
        <pc:spChg chg="mod">
          <ac:chgData name="Saika, Tomoya (EMC)" userId="38927815-4abc-4ee6-9bbe-be8bb685ce77" providerId="ADAL" clId="{7408F830-9E19-4D6D-A3BE-87A817EE8764}" dt="2018-09-25T06:57:35.838" v="568" actId="14100"/>
          <ac:spMkLst>
            <pc:docMk/>
            <pc:sldMk cId="2250013806" sldId="262"/>
            <ac:spMk id="5" creationId="{6A7BE03C-426D-4431-AFE0-D4691390C394}"/>
          </ac:spMkLst>
        </pc:spChg>
        <pc:picChg chg="add">
          <ac:chgData name="Saika, Tomoya (EMC)" userId="38927815-4abc-4ee6-9bbe-be8bb685ce77" providerId="ADAL" clId="{7408F830-9E19-4D6D-A3BE-87A817EE8764}" dt="2018-09-25T06:57:08.469" v="475"/>
          <ac:picMkLst>
            <pc:docMk/>
            <pc:sldMk cId="2250013806" sldId="262"/>
            <ac:picMk id="4" creationId="{D381F379-3B99-4435-BB69-CF05FF60A668}"/>
          </ac:picMkLst>
        </pc:picChg>
      </pc:sldChg>
      <pc:sldChg chg="addSp delSp modSp">
        <pc:chgData name="Saika, Tomoya (EMC)" userId="38927815-4abc-4ee6-9bbe-be8bb685ce77" providerId="ADAL" clId="{7408F830-9E19-4D6D-A3BE-87A817EE8764}" dt="2018-09-25T06:55:00.419" v="419"/>
        <pc:sldMkLst>
          <pc:docMk/>
          <pc:sldMk cId="2299167576" sldId="267"/>
        </pc:sldMkLst>
        <pc:spChg chg="mod">
          <ac:chgData name="Saika, Tomoya (EMC)" userId="38927815-4abc-4ee6-9bbe-be8bb685ce77" providerId="ADAL" clId="{7408F830-9E19-4D6D-A3BE-87A817EE8764}" dt="2018-09-25T06:33:58.046" v="126" actId="20577"/>
          <ac:spMkLst>
            <pc:docMk/>
            <pc:sldMk cId="2299167576" sldId="267"/>
            <ac:spMk id="3" creationId="{00000000-0000-0000-0000-000000000000}"/>
          </ac:spMkLst>
        </pc:spChg>
        <pc:spChg chg="add del">
          <ac:chgData name="Saika, Tomoya (EMC)" userId="38927815-4abc-4ee6-9bbe-be8bb685ce77" providerId="ADAL" clId="{7408F830-9E19-4D6D-A3BE-87A817EE8764}" dt="2018-09-25T06:48:21.554" v="250" actId="478"/>
          <ac:spMkLst>
            <pc:docMk/>
            <pc:sldMk cId="2299167576" sldId="267"/>
            <ac:spMk id="4" creationId="{00000000-0000-0000-0000-000000000000}"/>
          </ac:spMkLst>
        </pc:spChg>
        <pc:spChg chg="add del">
          <ac:chgData name="Saika, Tomoya (EMC)" userId="38927815-4abc-4ee6-9bbe-be8bb685ce77" providerId="ADAL" clId="{7408F830-9E19-4D6D-A3BE-87A817EE8764}" dt="2018-09-25T06:48:21.554" v="250" actId="478"/>
          <ac:spMkLst>
            <pc:docMk/>
            <pc:sldMk cId="2299167576" sldId="267"/>
            <ac:spMk id="5" creationId="{00000000-0000-0000-0000-000000000000}"/>
          </ac:spMkLst>
        </pc:spChg>
        <pc:spChg chg="mod">
          <ac:chgData name="Saika, Tomoya (EMC)" userId="38927815-4abc-4ee6-9bbe-be8bb685ce77" providerId="ADAL" clId="{7408F830-9E19-4D6D-A3BE-87A817EE8764}" dt="2018-09-25T06:55:00.419" v="419"/>
          <ac:spMkLst>
            <pc:docMk/>
            <pc:sldMk cId="2299167576" sldId="267"/>
            <ac:spMk id="6" creationId="{88685D5A-CC1D-4E3C-A0C4-67E0EA62847B}"/>
          </ac:spMkLst>
        </pc:spChg>
        <pc:graphicFrameChg chg="add del">
          <ac:chgData name="Saika, Tomoya (EMC)" userId="38927815-4abc-4ee6-9bbe-be8bb685ce77" providerId="ADAL" clId="{7408F830-9E19-4D6D-A3BE-87A817EE8764}" dt="2018-09-25T06:48:21.554" v="250" actId="478"/>
          <ac:graphicFrameMkLst>
            <pc:docMk/>
            <pc:sldMk cId="2299167576" sldId="267"/>
            <ac:graphicFrameMk id="2" creationId="{00000000-0000-0000-0000-000000000000}"/>
          </ac:graphicFrameMkLst>
        </pc:graphicFrameChg>
        <pc:picChg chg="add">
          <ac:chgData name="Saika, Tomoya (EMC)" userId="38927815-4abc-4ee6-9bbe-be8bb685ce77" providerId="ADAL" clId="{7408F830-9E19-4D6D-A3BE-87A817EE8764}" dt="2018-09-25T06:49:30.608" v="251"/>
          <ac:picMkLst>
            <pc:docMk/>
            <pc:sldMk cId="2299167576" sldId="267"/>
            <ac:picMk id="7" creationId="{02321D38-C1D4-4520-AE96-B57F14B1CEC6}"/>
          </ac:picMkLst>
        </pc:picChg>
      </pc:sldChg>
      <pc:sldChg chg="addSp delSp modSp add">
        <pc:chgData name="Saika, Tomoya (EMC)" userId="38927815-4abc-4ee6-9bbe-be8bb685ce77" providerId="ADAL" clId="{7408F830-9E19-4D6D-A3BE-87A817EE8764}" dt="2018-09-25T06:55:40.112" v="474"/>
        <pc:sldMkLst>
          <pc:docMk/>
          <pc:sldMk cId="450536261" sldId="268"/>
        </pc:sldMkLst>
        <pc:spChg chg="mod">
          <ac:chgData name="Saika, Tomoya (EMC)" userId="38927815-4abc-4ee6-9bbe-be8bb685ce77" providerId="ADAL" clId="{7408F830-9E19-4D6D-A3BE-87A817EE8764}" dt="2018-09-25T06:35:48.319" v="135" actId="20577"/>
          <ac:spMkLst>
            <pc:docMk/>
            <pc:sldMk cId="450536261" sldId="268"/>
            <ac:spMk id="3" creationId="{00000000-0000-0000-0000-000000000000}"/>
          </ac:spMkLst>
        </pc:spChg>
        <pc:spChg chg="mod">
          <ac:chgData name="Saika, Tomoya (EMC)" userId="38927815-4abc-4ee6-9bbe-be8bb685ce77" providerId="ADAL" clId="{7408F830-9E19-4D6D-A3BE-87A817EE8764}" dt="2018-09-25T06:55:40.112" v="474"/>
          <ac:spMkLst>
            <pc:docMk/>
            <pc:sldMk cId="450536261" sldId="268"/>
            <ac:spMk id="6" creationId="{88685D5A-CC1D-4E3C-A0C4-67E0EA62847B}"/>
          </ac:spMkLst>
        </pc:spChg>
        <pc:graphicFrameChg chg="mod">
          <ac:chgData name="Saika, Tomoya (EMC)" userId="38927815-4abc-4ee6-9bbe-be8bb685ce77" providerId="ADAL" clId="{7408F830-9E19-4D6D-A3BE-87A817EE8764}" dt="2018-09-25T06:45:38.374" v="181"/>
          <ac:graphicFrameMkLst>
            <pc:docMk/>
            <pc:sldMk cId="450536261" sldId="268"/>
            <ac:graphicFrameMk id="2" creationId="{00000000-0000-0000-0000-000000000000}"/>
          </ac:graphicFrameMkLst>
        </pc:graphicFrameChg>
        <pc:picChg chg="add del mod ord">
          <ac:chgData name="Saika, Tomoya (EMC)" userId="38927815-4abc-4ee6-9bbe-be8bb685ce77" providerId="ADAL" clId="{7408F830-9E19-4D6D-A3BE-87A817EE8764}" dt="2018-09-25T06:47:21.516" v="249" actId="478"/>
          <ac:picMkLst>
            <pc:docMk/>
            <pc:sldMk cId="450536261" sldId="268"/>
            <ac:picMk id="7" creationId="{454562F4-2A05-4581-8C8D-3166FA7E17C3}"/>
          </ac:picMkLst>
        </pc:picChg>
        <pc:picChg chg="add mod">
          <ac:chgData name="Saika, Tomoya (EMC)" userId="38927815-4abc-4ee6-9bbe-be8bb685ce77" providerId="ADAL" clId="{7408F830-9E19-4D6D-A3BE-87A817EE8764}" dt="2018-09-25T06:50:46.395" v="257" actId="1076"/>
          <ac:picMkLst>
            <pc:docMk/>
            <pc:sldMk cId="450536261" sldId="268"/>
            <ac:picMk id="8" creationId="{1D0D2496-2A98-4DB7-8559-5F854E87365C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7723" cy="4967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3141" y="0"/>
            <a:ext cx="2947723" cy="4967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09F3EBE-A200-478C-9ED4-38DFF5414572}" type="datetimeFigureOut">
              <a:rPr lang="en-US" smtClean="0"/>
              <a:t>12/18/2018</a:t>
            </a:fld>
            <a:endParaRPr lang="en-US" dirty="0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7288" cy="37258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244" y="4718923"/>
            <a:ext cx="5441950" cy="447055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36122"/>
            <a:ext cx="2947723" cy="49672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3141" y="9436122"/>
            <a:ext cx="2947723" cy="49672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BD81005-A304-466A-818C-BE6584A7E9F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206612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/>
              <a:t>マスター サブタイトルの書式設定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BA39CE-8FEB-4FFD-8C65-631016721E00}" type="datetimeFigureOut">
              <a:rPr lang="en-US" smtClean="0"/>
              <a:t>12/18/2018</a:t>
            </a:fld>
            <a:endParaRPr 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4EBEC1-CC78-4DFB-8DA1-8403E05E63B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105380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BA39CE-8FEB-4FFD-8C65-631016721E00}" type="datetimeFigureOut">
              <a:rPr lang="en-US" smtClean="0"/>
              <a:t>12/18/2018</a:t>
            </a:fld>
            <a:endParaRPr 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4EBEC1-CC78-4DFB-8DA1-8403E05E63B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167174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BA39CE-8FEB-4FFD-8C65-631016721E00}" type="datetimeFigureOut">
              <a:rPr lang="en-US" smtClean="0"/>
              <a:t>12/18/2018</a:t>
            </a:fld>
            <a:endParaRPr 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4EBEC1-CC78-4DFB-8DA1-8403E05E63B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932511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BA39CE-8FEB-4FFD-8C65-631016721E00}" type="datetimeFigureOut">
              <a:rPr lang="en-US" smtClean="0"/>
              <a:t>12/18/2018</a:t>
            </a:fld>
            <a:endParaRPr 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4EBEC1-CC78-4DFB-8DA1-8403E05E63B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416213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BA39CE-8FEB-4FFD-8C65-631016721E00}" type="datetimeFigureOut">
              <a:rPr lang="en-US" smtClean="0"/>
              <a:t>12/18/2018</a:t>
            </a:fld>
            <a:endParaRPr 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4EBEC1-CC78-4DFB-8DA1-8403E05E63B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407185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BA39CE-8FEB-4FFD-8C65-631016721E00}" type="datetimeFigureOut">
              <a:rPr lang="en-US" smtClean="0"/>
              <a:t>12/18/2018</a:t>
            </a:fld>
            <a:endParaRPr 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4EBEC1-CC78-4DFB-8DA1-8403E05E63B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640302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BA39CE-8FEB-4FFD-8C65-631016721E00}" type="datetimeFigureOut">
              <a:rPr lang="en-US" smtClean="0"/>
              <a:t>12/18/2018</a:t>
            </a:fld>
            <a:endParaRPr lang="en-US" dirty="0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4EBEC1-CC78-4DFB-8DA1-8403E05E63B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343526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130622"/>
            <a:ext cx="8229600" cy="63408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BA39CE-8FEB-4FFD-8C65-631016721E00}" type="datetimeFigureOut">
              <a:rPr lang="en-US" smtClean="0"/>
              <a:t>12/18/2018</a:t>
            </a:fld>
            <a:endParaRPr lang="en-US" dirty="0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4EBEC1-CC78-4DFB-8DA1-8403E05E63B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017333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BA39CE-8FEB-4FFD-8C65-631016721E00}" type="datetimeFigureOut">
              <a:rPr lang="en-US" smtClean="0"/>
              <a:t>12/18/2018</a:t>
            </a:fld>
            <a:endParaRPr lang="en-US" dirty="0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4EBEC1-CC78-4DFB-8DA1-8403E05E63B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967498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BA39CE-8FEB-4FFD-8C65-631016721E00}" type="datetimeFigureOut">
              <a:rPr lang="en-US" smtClean="0"/>
              <a:t>12/18/2018</a:t>
            </a:fld>
            <a:endParaRPr 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4EBEC1-CC78-4DFB-8DA1-8403E05E63B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719935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BA39CE-8FEB-4FFD-8C65-631016721E00}" type="datetimeFigureOut">
              <a:rPr lang="en-US" smtClean="0"/>
              <a:t>12/18/2018</a:t>
            </a:fld>
            <a:endParaRPr 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4EBEC1-CC78-4DFB-8DA1-8403E05E63B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167077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188640"/>
            <a:ext cx="8229600" cy="63408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268760"/>
            <a:ext cx="8229600" cy="48574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BA39CE-8FEB-4FFD-8C65-631016721E00}" type="datetimeFigureOut">
              <a:rPr lang="en-US" smtClean="0"/>
              <a:t>12/18/2018</a:t>
            </a:fld>
            <a:endParaRPr 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4EBEC1-CC78-4DFB-8DA1-8403E05E63B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01335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spcBef>
          <a:spcPct val="0"/>
        </a:spcBef>
        <a:buNone/>
        <a:defRPr sz="2800" kern="1200" baseline="0">
          <a:solidFill>
            <a:schemeClr val="tx1"/>
          </a:solidFill>
          <a:latin typeface="Arial" panose="020B0604020202020204" pitchFamily="34" charset="0"/>
          <a:ea typeface="ＭＳ Ｐゴシック" panose="020B0600070205080204" pitchFamily="50" charset="-128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xmlns="" id="{83E70581-15CD-4C0A-8799-846E71529B51}"/>
              </a:ext>
            </a:extLst>
          </p:cNvPr>
          <p:cNvGrpSpPr/>
          <p:nvPr/>
        </p:nvGrpSpPr>
        <p:grpSpPr>
          <a:xfrm>
            <a:off x="292825" y="909448"/>
            <a:ext cx="8551501" cy="5140054"/>
            <a:chOff x="292825" y="909448"/>
            <a:chExt cx="8551501" cy="5140054"/>
          </a:xfrm>
        </p:grpSpPr>
        <p:sp>
          <p:nvSpPr>
            <p:cNvPr id="154" name="テキスト ボックス 153"/>
            <p:cNvSpPr txBox="1"/>
            <p:nvPr/>
          </p:nvSpPr>
          <p:spPr>
            <a:xfrm>
              <a:off x="4377714" y="5710948"/>
              <a:ext cx="830164" cy="338554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kumimoji="1" lang="en-US" altLang="ja-JP" sz="1600" b="1" dirty="0">
                  <a:latin typeface="Arial" panose="020B0604020202020204" pitchFamily="34" charset="0"/>
                  <a:ea typeface="Meiryo UI" pitchFamily="50" charset="-128"/>
                  <a:cs typeface="Arial" panose="020B0604020202020204" pitchFamily="34" charset="0"/>
                </a:rPr>
                <a:t>Weeks</a:t>
              </a:r>
              <a:endParaRPr kumimoji="1" lang="ja-JP" altLang="en-US" sz="16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endParaRPr>
            </a:p>
          </p:txBody>
        </p:sp>
        <p:grpSp>
          <p:nvGrpSpPr>
            <p:cNvPr id="155" name="グループ化 154"/>
            <p:cNvGrpSpPr/>
            <p:nvPr/>
          </p:nvGrpSpPr>
          <p:grpSpPr>
            <a:xfrm>
              <a:off x="6128327" y="909448"/>
              <a:ext cx="2715999" cy="1139049"/>
              <a:chOff x="6668654" y="1945075"/>
              <a:chExt cx="2715999" cy="1139049"/>
            </a:xfrm>
          </p:grpSpPr>
          <p:grpSp>
            <p:nvGrpSpPr>
              <p:cNvPr id="156" name="グループ化 155"/>
              <p:cNvGrpSpPr/>
              <p:nvPr/>
            </p:nvGrpSpPr>
            <p:grpSpPr>
              <a:xfrm>
                <a:off x="6668654" y="1945075"/>
                <a:ext cx="1215588" cy="307777"/>
                <a:chOff x="6654800" y="2152893"/>
                <a:chExt cx="1215588" cy="307777"/>
              </a:xfrm>
            </p:grpSpPr>
            <p:grpSp>
              <p:nvGrpSpPr>
                <p:cNvPr id="177" name="グループ化 176"/>
                <p:cNvGrpSpPr/>
                <p:nvPr/>
              </p:nvGrpSpPr>
              <p:grpSpPr>
                <a:xfrm>
                  <a:off x="6654800" y="2252781"/>
                  <a:ext cx="360000" cy="108000"/>
                  <a:chOff x="7131050" y="2241525"/>
                  <a:chExt cx="360000" cy="108000"/>
                </a:xfrm>
              </p:grpSpPr>
              <p:cxnSp>
                <p:nvCxnSpPr>
                  <p:cNvPr id="179" name="直線コネクタ 178"/>
                  <p:cNvCxnSpPr/>
                  <p:nvPr/>
                </p:nvCxnSpPr>
                <p:spPr>
                  <a:xfrm>
                    <a:off x="7131050" y="2295525"/>
                    <a:ext cx="360000" cy="0"/>
                  </a:xfrm>
                  <a:prstGeom prst="line">
                    <a:avLst/>
                  </a:prstGeom>
                  <a:ln w="12700">
                    <a:solidFill>
                      <a:srgbClr val="7F7F7F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80" name="ひし形 179"/>
                  <p:cNvSpPr/>
                  <p:nvPr/>
                </p:nvSpPr>
                <p:spPr>
                  <a:xfrm>
                    <a:off x="7257075" y="2241525"/>
                    <a:ext cx="107950" cy="108000"/>
                  </a:xfrm>
                  <a:prstGeom prst="diamond">
                    <a:avLst/>
                  </a:prstGeom>
                  <a:solidFill>
                    <a:srgbClr val="7F7F7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</p:grpSp>
            <p:sp>
              <p:nvSpPr>
                <p:cNvPr id="178" name="テキスト ボックス 177"/>
                <p:cNvSpPr txBox="1"/>
                <p:nvPr/>
              </p:nvSpPr>
              <p:spPr>
                <a:xfrm>
                  <a:off x="7038109" y="2152893"/>
                  <a:ext cx="832279" cy="307777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r>
                    <a:rPr kumimoji="1" lang="en-US" altLang="ja-JP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lacebo</a:t>
                  </a:r>
                  <a:endParaRPr kumimoji="1" lang="ja-JP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57" name="グループ化 156"/>
              <p:cNvGrpSpPr/>
              <p:nvPr/>
            </p:nvGrpSpPr>
            <p:grpSpPr>
              <a:xfrm>
                <a:off x="6668654" y="2152893"/>
                <a:ext cx="2656688" cy="307777"/>
                <a:chOff x="6654800" y="2152893"/>
                <a:chExt cx="2656688" cy="307777"/>
              </a:xfrm>
            </p:grpSpPr>
            <p:grpSp>
              <p:nvGrpSpPr>
                <p:cNvPr id="173" name="グループ化 172"/>
                <p:cNvGrpSpPr/>
                <p:nvPr/>
              </p:nvGrpSpPr>
              <p:grpSpPr>
                <a:xfrm>
                  <a:off x="6654800" y="2252781"/>
                  <a:ext cx="360000" cy="108000"/>
                  <a:chOff x="7131050" y="2241525"/>
                  <a:chExt cx="360000" cy="108000"/>
                </a:xfrm>
              </p:grpSpPr>
              <p:cxnSp>
                <p:nvCxnSpPr>
                  <p:cNvPr id="175" name="直線コネクタ 174"/>
                  <p:cNvCxnSpPr/>
                  <p:nvPr/>
                </p:nvCxnSpPr>
                <p:spPr>
                  <a:xfrm>
                    <a:off x="7131050" y="2295525"/>
                    <a:ext cx="360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76" name="正方形/長方形 175"/>
                  <p:cNvSpPr/>
                  <p:nvPr/>
                </p:nvSpPr>
                <p:spPr>
                  <a:xfrm>
                    <a:off x="7257075" y="2241525"/>
                    <a:ext cx="107950" cy="108000"/>
                  </a:xfrm>
                  <a:prstGeom prst="rect">
                    <a:avLst/>
                  </a:prstGeom>
                  <a:solidFill>
                    <a:schemeClr val="tx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</p:grpSp>
            <p:sp>
              <p:nvSpPr>
                <p:cNvPr id="174" name="テキスト ボックス 173"/>
                <p:cNvSpPr txBox="1"/>
                <p:nvPr/>
              </p:nvSpPr>
              <p:spPr>
                <a:xfrm>
                  <a:off x="7038109" y="2152893"/>
                  <a:ext cx="2273379" cy="307777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r>
                    <a:rPr kumimoji="1" lang="en-US" altLang="ja-JP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saxerenone 1.25 mg/day</a:t>
                  </a:r>
                  <a:endParaRPr kumimoji="1" lang="ja-JP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58" name="グループ化 157"/>
              <p:cNvGrpSpPr/>
              <p:nvPr/>
            </p:nvGrpSpPr>
            <p:grpSpPr>
              <a:xfrm>
                <a:off x="6668654" y="2360711"/>
                <a:ext cx="2557302" cy="307777"/>
                <a:chOff x="6654800" y="2152893"/>
                <a:chExt cx="2557302" cy="307777"/>
              </a:xfrm>
            </p:grpSpPr>
            <p:grpSp>
              <p:nvGrpSpPr>
                <p:cNvPr id="169" name="グループ化 168"/>
                <p:cNvGrpSpPr/>
                <p:nvPr/>
              </p:nvGrpSpPr>
              <p:grpSpPr>
                <a:xfrm>
                  <a:off x="6654800" y="2252781"/>
                  <a:ext cx="360000" cy="108000"/>
                  <a:chOff x="7131050" y="2241525"/>
                  <a:chExt cx="360000" cy="108000"/>
                </a:xfrm>
              </p:grpSpPr>
              <p:cxnSp>
                <p:nvCxnSpPr>
                  <p:cNvPr id="171" name="直線コネクタ 170"/>
                  <p:cNvCxnSpPr/>
                  <p:nvPr/>
                </p:nvCxnSpPr>
                <p:spPr>
                  <a:xfrm>
                    <a:off x="7131050" y="2295525"/>
                    <a:ext cx="360000" cy="0"/>
                  </a:xfrm>
                  <a:prstGeom prst="line">
                    <a:avLst/>
                  </a:prstGeom>
                  <a:ln w="12700" cap="rnd">
                    <a:solidFill>
                      <a:schemeClr val="tx1"/>
                    </a:solidFill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72" name="二等辺三角形 171"/>
                  <p:cNvSpPr/>
                  <p:nvPr/>
                </p:nvSpPr>
                <p:spPr>
                  <a:xfrm>
                    <a:off x="7257075" y="2241525"/>
                    <a:ext cx="107950" cy="108000"/>
                  </a:xfrm>
                  <a:prstGeom prst="triangle">
                    <a:avLst/>
                  </a:prstGeom>
                  <a:solidFill>
                    <a:schemeClr val="tx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</p:grpSp>
            <p:sp>
              <p:nvSpPr>
                <p:cNvPr id="170" name="テキスト ボックス 169"/>
                <p:cNvSpPr txBox="1"/>
                <p:nvPr/>
              </p:nvSpPr>
              <p:spPr>
                <a:xfrm>
                  <a:off x="7038109" y="2152893"/>
                  <a:ext cx="2173993" cy="307777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r>
                    <a:rPr kumimoji="1" lang="en-US" altLang="ja-JP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saxerenone 2.5 mg/day</a:t>
                  </a:r>
                  <a:endParaRPr kumimoji="1" lang="ja-JP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59" name="グループ化 158"/>
              <p:cNvGrpSpPr/>
              <p:nvPr/>
            </p:nvGrpSpPr>
            <p:grpSpPr>
              <a:xfrm>
                <a:off x="6668654" y="2568529"/>
                <a:ext cx="2408222" cy="307777"/>
                <a:chOff x="6654800" y="2152893"/>
                <a:chExt cx="2408222" cy="307777"/>
              </a:xfrm>
            </p:grpSpPr>
            <p:grpSp>
              <p:nvGrpSpPr>
                <p:cNvPr id="165" name="グループ化 164"/>
                <p:cNvGrpSpPr/>
                <p:nvPr/>
              </p:nvGrpSpPr>
              <p:grpSpPr>
                <a:xfrm>
                  <a:off x="6654800" y="2234781"/>
                  <a:ext cx="360000" cy="144000"/>
                  <a:chOff x="7131050" y="2223525"/>
                  <a:chExt cx="360000" cy="144000"/>
                </a:xfrm>
              </p:grpSpPr>
              <p:cxnSp>
                <p:nvCxnSpPr>
                  <p:cNvPr id="167" name="直線コネクタ 166"/>
                  <p:cNvCxnSpPr/>
                  <p:nvPr/>
                </p:nvCxnSpPr>
                <p:spPr>
                  <a:xfrm>
                    <a:off x="7131050" y="2295525"/>
                    <a:ext cx="360000" cy="0"/>
                  </a:xfrm>
                  <a:prstGeom prst="line">
                    <a:avLst/>
                  </a:prstGeom>
                  <a:ln w="12700" cap="rnd">
                    <a:solidFill>
                      <a:schemeClr val="tx1"/>
                    </a:solidFill>
                    <a:prstDash val="sysDot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68" name="乗算記号 167"/>
                  <p:cNvSpPr/>
                  <p:nvPr/>
                </p:nvSpPr>
                <p:spPr>
                  <a:xfrm>
                    <a:off x="7239050" y="2223525"/>
                    <a:ext cx="144000" cy="144000"/>
                  </a:xfrm>
                  <a:prstGeom prst="mathMultiply">
                    <a:avLst>
                      <a:gd name="adj1" fmla="val 8080"/>
                    </a:avLst>
                  </a:prstGeom>
                  <a:solidFill>
                    <a:schemeClr val="tx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</p:grpSp>
            <p:sp>
              <p:nvSpPr>
                <p:cNvPr id="166" name="テキスト ボックス 165"/>
                <p:cNvSpPr txBox="1"/>
                <p:nvPr/>
              </p:nvSpPr>
              <p:spPr>
                <a:xfrm>
                  <a:off x="7038109" y="2152893"/>
                  <a:ext cx="2024913" cy="307777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r>
                    <a:rPr kumimoji="1" lang="en-US" altLang="ja-JP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saxerenone 5 mg/day</a:t>
                  </a:r>
                </a:p>
              </p:txBody>
            </p:sp>
          </p:grpSp>
          <p:grpSp>
            <p:nvGrpSpPr>
              <p:cNvPr id="160" name="グループ化 159"/>
              <p:cNvGrpSpPr/>
              <p:nvPr/>
            </p:nvGrpSpPr>
            <p:grpSpPr>
              <a:xfrm>
                <a:off x="6668654" y="2776347"/>
                <a:ext cx="2715999" cy="307777"/>
                <a:chOff x="6654800" y="2152893"/>
                <a:chExt cx="2715999" cy="307777"/>
              </a:xfrm>
            </p:grpSpPr>
            <p:grpSp>
              <p:nvGrpSpPr>
                <p:cNvPr id="161" name="グループ化 160"/>
                <p:cNvGrpSpPr/>
                <p:nvPr/>
              </p:nvGrpSpPr>
              <p:grpSpPr>
                <a:xfrm>
                  <a:off x="6654800" y="2252781"/>
                  <a:ext cx="360000" cy="108000"/>
                  <a:chOff x="7131050" y="2241525"/>
                  <a:chExt cx="360000" cy="108000"/>
                </a:xfrm>
              </p:grpSpPr>
              <p:cxnSp>
                <p:nvCxnSpPr>
                  <p:cNvPr id="163" name="直線コネクタ 162"/>
                  <p:cNvCxnSpPr/>
                  <p:nvPr/>
                </p:nvCxnSpPr>
                <p:spPr>
                  <a:xfrm>
                    <a:off x="7131050" y="2295525"/>
                    <a:ext cx="360000" cy="0"/>
                  </a:xfrm>
                  <a:prstGeom prst="line">
                    <a:avLst/>
                  </a:prstGeom>
                  <a:ln w="12700" cap="rnd">
                    <a:solidFill>
                      <a:schemeClr val="tx1"/>
                    </a:solidFill>
                    <a:prstDash val="lgDashDotDot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64" name="円/楕円 163"/>
                  <p:cNvSpPr/>
                  <p:nvPr/>
                </p:nvSpPr>
                <p:spPr>
                  <a:xfrm>
                    <a:off x="7257075" y="2241525"/>
                    <a:ext cx="107950" cy="108000"/>
                  </a:xfrm>
                  <a:prstGeom prst="ellipse">
                    <a:avLst/>
                  </a:prstGeom>
                  <a:solidFill>
                    <a:schemeClr val="tx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</p:grpSp>
            <p:sp>
              <p:nvSpPr>
                <p:cNvPr id="162" name="テキスト ボックス 161"/>
                <p:cNvSpPr txBox="1"/>
                <p:nvPr/>
              </p:nvSpPr>
              <p:spPr>
                <a:xfrm>
                  <a:off x="7038109" y="2152893"/>
                  <a:ext cx="2332690" cy="307777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r>
                    <a:rPr kumimoji="1" lang="en-US" altLang="ja-JP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plerenone 50/100 mg/day</a:t>
                  </a:r>
                  <a:endParaRPr kumimoji="1" lang="ja-JP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cxnSp>
          <p:nvCxnSpPr>
            <p:cNvPr id="4" name="直線コネクタ 3"/>
            <p:cNvCxnSpPr/>
            <p:nvPr/>
          </p:nvCxnSpPr>
          <p:spPr>
            <a:xfrm>
              <a:off x="1226820" y="5234940"/>
              <a:ext cx="730123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7" name="直線コネクタ 186"/>
            <p:cNvCxnSpPr/>
            <p:nvPr/>
          </p:nvCxnSpPr>
          <p:spPr>
            <a:xfrm>
              <a:off x="1226820" y="1501140"/>
              <a:ext cx="0" cy="37338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1" name="直線コネクタ 190"/>
            <p:cNvCxnSpPr/>
            <p:nvPr/>
          </p:nvCxnSpPr>
          <p:spPr>
            <a:xfrm>
              <a:off x="8526780" y="5234940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2" name="直線コネクタ 191"/>
            <p:cNvCxnSpPr/>
            <p:nvPr/>
          </p:nvCxnSpPr>
          <p:spPr>
            <a:xfrm>
              <a:off x="7483926" y="5234940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3" name="直線コネクタ 192"/>
            <p:cNvCxnSpPr/>
            <p:nvPr/>
          </p:nvCxnSpPr>
          <p:spPr>
            <a:xfrm>
              <a:off x="6441075" y="5234940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4" name="直線コネクタ 193"/>
            <p:cNvCxnSpPr/>
            <p:nvPr/>
          </p:nvCxnSpPr>
          <p:spPr>
            <a:xfrm>
              <a:off x="5398224" y="5234940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5" name="直線コネクタ 194"/>
            <p:cNvCxnSpPr/>
            <p:nvPr/>
          </p:nvCxnSpPr>
          <p:spPr>
            <a:xfrm>
              <a:off x="4355373" y="5234940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6" name="直線コネクタ 195"/>
            <p:cNvCxnSpPr/>
            <p:nvPr/>
          </p:nvCxnSpPr>
          <p:spPr>
            <a:xfrm>
              <a:off x="3312522" y="5234940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7" name="直線コネクタ 196"/>
            <p:cNvCxnSpPr/>
            <p:nvPr/>
          </p:nvCxnSpPr>
          <p:spPr>
            <a:xfrm>
              <a:off x="2269671" y="5234940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8" name="直線コネクタ 197"/>
            <p:cNvCxnSpPr/>
            <p:nvPr/>
          </p:nvCxnSpPr>
          <p:spPr>
            <a:xfrm>
              <a:off x="1226820" y="5234940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9" name="直線コネクタ 198"/>
            <p:cNvCxnSpPr/>
            <p:nvPr/>
          </p:nvCxnSpPr>
          <p:spPr>
            <a:xfrm>
              <a:off x="1154820" y="5234940"/>
              <a:ext cx="72000" cy="0"/>
            </a:xfrm>
            <a:prstGeom prst="line">
              <a:avLst/>
            </a:prstGeom>
            <a:ln w="19050" cap="flat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5" name="直線コネクタ 214"/>
            <p:cNvCxnSpPr/>
            <p:nvPr/>
          </p:nvCxnSpPr>
          <p:spPr>
            <a:xfrm>
              <a:off x="1154820" y="3990340"/>
              <a:ext cx="72000" cy="0"/>
            </a:xfrm>
            <a:prstGeom prst="line">
              <a:avLst/>
            </a:prstGeom>
            <a:ln w="19050" cap="flat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6" name="直線コネクタ 215"/>
            <p:cNvCxnSpPr/>
            <p:nvPr/>
          </p:nvCxnSpPr>
          <p:spPr>
            <a:xfrm>
              <a:off x="1154820" y="2745740"/>
              <a:ext cx="72000" cy="0"/>
            </a:xfrm>
            <a:prstGeom prst="line">
              <a:avLst/>
            </a:prstGeom>
            <a:ln w="19050" cap="flat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7" name="直線コネクタ 216"/>
            <p:cNvCxnSpPr/>
            <p:nvPr/>
          </p:nvCxnSpPr>
          <p:spPr>
            <a:xfrm>
              <a:off x="1154820" y="1501140"/>
              <a:ext cx="72000" cy="0"/>
            </a:xfrm>
            <a:prstGeom prst="line">
              <a:avLst/>
            </a:prstGeom>
            <a:ln w="19050" cap="flat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8" name="テキスト ボックス 217"/>
            <p:cNvSpPr txBox="1"/>
            <p:nvPr/>
          </p:nvSpPr>
          <p:spPr>
            <a:xfrm>
              <a:off x="832689" y="5109414"/>
              <a:ext cx="285335" cy="246221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r"/>
              <a:r>
                <a:rPr kumimoji="1" lang="en-US" altLang="ja-JP" sz="1600" dirty="0">
                  <a:latin typeface="Arial" panose="020B0604020202020204" pitchFamily="34" charset="0"/>
                  <a:ea typeface="Meiryo UI" pitchFamily="50" charset="-128"/>
                  <a:cs typeface="Arial" panose="020B0604020202020204" pitchFamily="34" charset="0"/>
                </a:rPr>
                <a:t>3.5</a:t>
              </a:r>
              <a:endParaRPr kumimoji="1" lang="ja-JP" altLang="en-US" sz="16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33" name="テキスト ボックス 232"/>
            <p:cNvSpPr txBox="1"/>
            <p:nvPr/>
          </p:nvSpPr>
          <p:spPr>
            <a:xfrm>
              <a:off x="832689" y="3865873"/>
              <a:ext cx="285335" cy="246221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r"/>
              <a:r>
                <a:rPr kumimoji="1" lang="en-US" altLang="ja-JP" sz="1600" dirty="0">
                  <a:latin typeface="Arial" panose="020B0604020202020204" pitchFamily="34" charset="0"/>
                  <a:ea typeface="Meiryo UI" pitchFamily="50" charset="-128"/>
                  <a:cs typeface="Arial" panose="020B0604020202020204" pitchFamily="34" charset="0"/>
                </a:rPr>
                <a:t>4.0</a:t>
              </a:r>
              <a:endParaRPr kumimoji="1" lang="ja-JP" altLang="en-US" sz="16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34" name="テキスト ボックス 233"/>
            <p:cNvSpPr txBox="1"/>
            <p:nvPr/>
          </p:nvSpPr>
          <p:spPr>
            <a:xfrm>
              <a:off x="832689" y="2622331"/>
              <a:ext cx="285335" cy="246221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r"/>
              <a:r>
                <a:rPr kumimoji="1" lang="en-US" altLang="ja-JP" sz="1600" dirty="0">
                  <a:latin typeface="Arial" panose="020B0604020202020204" pitchFamily="34" charset="0"/>
                  <a:ea typeface="Meiryo UI" pitchFamily="50" charset="-128"/>
                  <a:cs typeface="Arial" panose="020B0604020202020204" pitchFamily="34" charset="0"/>
                </a:rPr>
                <a:t>4.5</a:t>
              </a:r>
              <a:endParaRPr kumimoji="1" lang="ja-JP" altLang="en-US" sz="16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35" name="テキスト ボックス 234"/>
            <p:cNvSpPr txBox="1"/>
            <p:nvPr/>
          </p:nvSpPr>
          <p:spPr>
            <a:xfrm>
              <a:off x="832689" y="1378789"/>
              <a:ext cx="285335" cy="246221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r"/>
              <a:r>
                <a:rPr kumimoji="1" lang="en-US" altLang="ja-JP" sz="1600" dirty="0">
                  <a:latin typeface="Arial" panose="020B0604020202020204" pitchFamily="34" charset="0"/>
                  <a:ea typeface="Meiryo UI" pitchFamily="50" charset="-128"/>
                  <a:cs typeface="Arial" panose="020B0604020202020204" pitchFamily="34" charset="0"/>
                </a:rPr>
                <a:t>5.0</a:t>
              </a:r>
              <a:endParaRPr kumimoji="1" lang="ja-JP" altLang="en-US" sz="16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36" name="テキスト ボックス 235"/>
            <p:cNvSpPr txBox="1"/>
            <p:nvPr/>
          </p:nvSpPr>
          <p:spPr>
            <a:xfrm rot="16200000">
              <a:off x="-543943" y="3198763"/>
              <a:ext cx="2012089" cy="338554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kumimoji="1" lang="en-US" altLang="ja-JP" sz="1600" b="1" dirty="0">
                  <a:latin typeface="Arial" panose="020B0604020202020204" pitchFamily="34" charset="0"/>
                  <a:ea typeface="Meiryo UI" pitchFamily="50" charset="-128"/>
                  <a:cs typeface="Arial" panose="020B0604020202020204" pitchFamily="34" charset="0"/>
                </a:rPr>
                <a:t>Serum K</a:t>
              </a:r>
              <a:r>
                <a:rPr lang="en-US" baseline="30000" dirty="0"/>
                <a:t>+</a:t>
              </a:r>
              <a:r>
                <a:rPr kumimoji="1" lang="en-US" altLang="ja-JP" sz="1600" b="1" dirty="0">
                  <a:latin typeface="Arial" panose="020B0604020202020204" pitchFamily="34" charset="0"/>
                  <a:ea typeface="Meiryo UI" pitchFamily="50" charset="-128"/>
                  <a:cs typeface="Arial" panose="020B0604020202020204" pitchFamily="34" charset="0"/>
                </a:rPr>
                <a:t> (mmol/L)</a:t>
              </a:r>
              <a:endParaRPr kumimoji="1" lang="ja-JP" altLang="en-US" sz="16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37" name="テキスト ボックス 236"/>
            <p:cNvSpPr txBox="1"/>
            <p:nvPr/>
          </p:nvSpPr>
          <p:spPr>
            <a:xfrm>
              <a:off x="835337" y="5359786"/>
              <a:ext cx="783869" cy="246221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ctr"/>
              <a:r>
                <a:rPr kumimoji="1" lang="en-US" altLang="ja-JP" sz="1600" dirty="0">
                  <a:latin typeface="Arial" panose="020B0604020202020204" pitchFamily="34" charset="0"/>
                  <a:ea typeface="Meiryo UI" pitchFamily="50" charset="-128"/>
                  <a:cs typeface="Arial" panose="020B0604020202020204" pitchFamily="34" charset="0"/>
                </a:rPr>
                <a:t>Baseline</a:t>
              </a:r>
              <a:endParaRPr kumimoji="1" lang="ja-JP" altLang="en-US" sz="16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38" name="テキスト ボックス 237"/>
            <p:cNvSpPr txBox="1"/>
            <p:nvPr/>
          </p:nvSpPr>
          <p:spPr>
            <a:xfrm>
              <a:off x="2213579" y="5359786"/>
              <a:ext cx="113813" cy="246221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ctr"/>
              <a:r>
                <a:rPr kumimoji="1" lang="en-US" altLang="ja-JP" sz="1600" dirty="0">
                  <a:latin typeface="Arial" panose="020B0604020202020204" pitchFamily="34" charset="0"/>
                  <a:ea typeface="Meiryo UI" pitchFamily="50" charset="-128"/>
                  <a:cs typeface="Arial" panose="020B0604020202020204" pitchFamily="34" charset="0"/>
                </a:rPr>
                <a:t>1</a:t>
              </a:r>
              <a:endParaRPr kumimoji="1" lang="ja-JP" altLang="en-US" sz="16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39" name="テキスト ボックス 238"/>
            <p:cNvSpPr txBox="1"/>
            <p:nvPr/>
          </p:nvSpPr>
          <p:spPr>
            <a:xfrm>
              <a:off x="3256793" y="5359786"/>
              <a:ext cx="113813" cy="246221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ctr"/>
              <a:r>
                <a:rPr kumimoji="1" lang="en-US" altLang="ja-JP" sz="1600" dirty="0">
                  <a:latin typeface="Arial" panose="020B0604020202020204" pitchFamily="34" charset="0"/>
                  <a:ea typeface="Meiryo UI" pitchFamily="50" charset="-128"/>
                  <a:cs typeface="Arial" panose="020B0604020202020204" pitchFamily="34" charset="0"/>
                </a:rPr>
                <a:t>2</a:t>
              </a:r>
              <a:endParaRPr kumimoji="1" lang="ja-JP" altLang="en-US" sz="16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40" name="テキスト ボックス 239"/>
            <p:cNvSpPr txBox="1"/>
            <p:nvPr/>
          </p:nvSpPr>
          <p:spPr>
            <a:xfrm>
              <a:off x="4300007" y="5359786"/>
              <a:ext cx="113813" cy="246221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ctr"/>
              <a:r>
                <a:rPr kumimoji="1" lang="en-US" altLang="ja-JP" sz="1600" dirty="0">
                  <a:latin typeface="Arial" panose="020B0604020202020204" pitchFamily="34" charset="0"/>
                  <a:ea typeface="Meiryo UI" pitchFamily="50" charset="-128"/>
                  <a:cs typeface="Arial" panose="020B0604020202020204" pitchFamily="34" charset="0"/>
                </a:rPr>
                <a:t>4</a:t>
              </a:r>
              <a:endParaRPr kumimoji="1" lang="ja-JP" altLang="en-US" sz="16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41" name="テキスト ボックス 240"/>
            <p:cNvSpPr txBox="1"/>
            <p:nvPr/>
          </p:nvSpPr>
          <p:spPr>
            <a:xfrm>
              <a:off x="5343221" y="5359786"/>
              <a:ext cx="113813" cy="246221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ctr"/>
              <a:r>
                <a:rPr kumimoji="1" lang="en-US" altLang="ja-JP" sz="1600" dirty="0">
                  <a:latin typeface="Arial" panose="020B0604020202020204" pitchFamily="34" charset="0"/>
                  <a:ea typeface="Meiryo UI" pitchFamily="50" charset="-128"/>
                  <a:cs typeface="Arial" panose="020B0604020202020204" pitchFamily="34" charset="0"/>
                </a:rPr>
                <a:t>6</a:t>
              </a:r>
              <a:endParaRPr kumimoji="1" lang="ja-JP" altLang="en-US" sz="16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42" name="テキスト ボックス 241"/>
            <p:cNvSpPr txBox="1"/>
            <p:nvPr/>
          </p:nvSpPr>
          <p:spPr>
            <a:xfrm>
              <a:off x="6386435" y="5359786"/>
              <a:ext cx="113813" cy="246221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ctr"/>
              <a:r>
                <a:rPr kumimoji="1" lang="en-US" altLang="ja-JP" sz="1600" dirty="0">
                  <a:latin typeface="Arial" panose="020B0604020202020204" pitchFamily="34" charset="0"/>
                  <a:ea typeface="Meiryo UI" pitchFamily="50" charset="-128"/>
                  <a:cs typeface="Arial" panose="020B0604020202020204" pitchFamily="34" charset="0"/>
                </a:rPr>
                <a:t>8</a:t>
              </a:r>
              <a:endParaRPr kumimoji="1" lang="ja-JP" altLang="en-US" sz="16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43" name="テキスト ボックス 242"/>
            <p:cNvSpPr txBox="1"/>
            <p:nvPr/>
          </p:nvSpPr>
          <p:spPr>
            <a:xfrm>
              <a:off x="7372742" y="5359786"/>
              <a:ext cx="227627" cy="246221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ctr"/>
              <a:r>
                <a:rPr kumimoji="1" lang="en-US" altLang="ja-JP" sz="1600" dirty="0">
                  <a:latin typeface="Arial" panose="020B0604020202020204" pitchFamily="34" charset="0"/>
                  <a:ea typeface="Meiryo UI" pitchFamily="50" charset="-128"/>
                  <a:cs typeface="Arial" panose="020B0604020202020204" pitchFamily="34" charset="0"/>
                </a:rPr>
                <a:t>10</a:t>
              </a:r>
              <a:endParaRPr kumimoji="1" lang="ja-JP" altLang="en-US" sz="16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44" name="テキスト ボックス 243"/>
            <p:cNvSpPr txBox="1"/>
            <p:nvPr/>
          </p:nvSpPr>
          <p:spPr>
            <a:xfrm>
              <a:off x="8415958" y="5359786"/>
              <a:ext cx="227627" cy="246221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ctr"/>
              <a:r>
                <a:rPr kumimoji="1" lang="en-US" altLang="ja-JP" sz="1600" dirty="0">
                  <a:latin typeface="Arial" panose="020B0604020202020204" pitchFamily="34" charset="0"/>
                  <a:ea typeface="Meiryo UI" pitchFamily="50" charset="-128"/>
                  <a:cs typeface="Arial" panose="020B0604020202020204" pitchFamily="34" charset="0"/>
                </a:rPr>
                <a:t>12</a:t>
              </a:r>
              <a:endParaRPr kumimoji="1" lang="ja-JP" altLang="en-US" sz="16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endParaRPr>
            </a:p>
          </p:txBody>
        </p:sp>
        <p:grpSp>
          <p:nvGrpSpPr>
            <p:cNvPr id="346" name="グループ化 345"/>
            <p:cNvGrpSpPr/>
            <p:nvPr/>
          </p:nvGrpSpPr>
          <p:grpSpPr>
            <a:xfrm>
              <a:off x="1173271" y="2583657"/>
              <a:ext cx="7410500" cy="2038349"/>
              <a:chOff x="1173271" y="2583657"/>
              <a:chExt cx="7410500" cy="2038349"/>
            </a:xfrm>
          </p:grpSpPr>
          <p:grpSp>
            <p:nvGrpSpPr>
              <p:cNvPr id="347" name="グループ化 346"/>
              <p:cNvGrpSpPr/>
              <p:nvPr/>
            </p:nvGrpSpPr>
            <p:grpSpPr>
              <a:xfrm>
                <a:off x="8475771" y="3336925"/>
                <a:ext cx="108000" cy="1279525"/>
                <a:chOff x="8793480" y="2636520"/>
                <a:chExt cx="182880" cy="1203960"/>
              </a:xfrm>
            </p:grpSpPr>
            <p:cxnSp>
              <p:nvCxnSpPr>
                <p:cNvPr id="376" name="直線コネクタ 375"/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77" name="直線コネクタ 376"/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78" name="直線コネクタ 377"/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48" name="グループ化 347"/>
              <p:cNvGrpSpPr/>
              <p:nvPr/>
            </p:nvGrpSpPr>
            <p:grpSpPr>
              <a:xfrm>
                <a:off x="7432555" y="2790825"/>
                <a:ext cx="108000" cy="1498600"/>
                <a:chOff x="8793480" y="2636520"/>
                <a:chExt cx="182880" cy="1203960"/>
              </a:xfrm>
            </p:grpSpPr>
            <p:cxnSp>
              <p:nvCxnSpPr>
                <p:cNvPr id="373" name="直線コネクタ 372"/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74" name="直線コネクタ 373"/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75" name="直線コネクタ 374"/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49" name="グループ化 348"/>
              <p:cNvGrpSpPr/>
              <p:nvPr/>
            </p:nvGrpSpPr>
            <p:grpSpPr>
              <a:xfrm>
                <a:off x="6389341" y="2947988"/>
                <a:ext cx="108000" cy="1674018"/>
                <a:chOff x="8793480" y="2636520"/>
                <a:chExt cx="182880" cy="1203960"/>
              </a:xfrm>
            </p:grpSpPr>
            <p:cxnSp>
              <p:nvCxnSpPr>
                <p:cNvPr id="370" name="直線コネクタ 369"/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71" name="直線コネクタ 370"/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72" name="直線コネクタ 371"/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50" name="グループ化 349"/>
              <p:cNvGrpSpPr/>
              <p:nvPr/>
            </p:nvGrpSpPr>
            <p:grpSpPr>
              <a:xfrm>
                <a:off x="5346127" y="2709863"/>
                <a:ext cx="108000" cy="1447801"/>
                <a:chOff x="8793480" y="2636520"/>
                <a:chExt cx="182880" cy="1203960"/>
              </a:xfrm>
            </p:grpSpPr>
            <p:cxnSp>
              <p:nvCxnSpPr>
                <p:cNvPr id="367" name="直線コネクタ 366"/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8" name="直線コネクタ 367"/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9" name="直線コネクタ 368"/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51" name="グループ化 350"/>
              <p:cNvGrpSpPr/>
              <p:nvPr/>
            </p:nvGrpSpPr>
            <p:grpSpPr>
              <a:xfrm>
                <a:off x="4302913" y="3288506"/>
                <a:ext cx="108000" cy="1166813"/>
                <a:chOff x="8793480" y="2636520"/>
                <a:chExt cx="182880" cy="1203960"/>
              </a:xfrm>
            </p:grpSpPr>
            <p:cxnSp>
              <p:nvCxnSpPr>
                <p:cNvPr id="364" name="直線コネクタ 363"/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5" name="直線コネクタ 364"/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6" name="直線コネクタ 365"/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52" name="グループ化 351"/>
              <p:cNvGrpSpPr/>
              <p:nvPr/>
            </p:nvGrpSpPr>
            <p:grpSpPr>
              <a:xfrm>
                <a:off x="3259699" y="2616995"/>
                <a:ext cx="108000" cy="1371600"/>
                <a:chOff x="8793480" y="2636520"/>
                <a:chExt cx="182880" cy="1203960"/>
              </a:xfrm>
            </p:grpSpPr>
            <p:cxnSp>
              <p:nvCxnSpPr>
                <p:cNvPr id="361" name="直線コネクタ 360"/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2" name="直線コネクタ 361"/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3" name="直線コネクタ 362"/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53" name="グループ化 352"/>
              <p:cNvGrpSpPr/>
              <p:nvPr/>
            </p:nvGrpSpPr>
            <p:grpSpPr>
              <a:xfrm>
                <a:off x="2216485" y="2583657"/>
                <a:ext cx="108000" cy="1402556"/>
                <a:chOff x="8793480" y="2636520"/>
                <a:chExt cx="182880" cy="1203960"/>
              </a:xfrm>
            </p:grpSpPr>
            <p:cxnSp>
              <p:nvCxnSpPr>
                <p:cNvPr id="358" name="直線コネクタ 357"/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59" name="直線コネクタ 358"/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0" name="直線コネクタ 359"/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54" name="グループ化 353"/>
              <p:cNvGrpSpPr/>
              <p:nvPr/>
            </p:nvGrpSpPr>
            <p:grpSpPr>
              <a:xfrm>
                <a:off x="1173271" y="3124200"/>
                <a:ext cx="108000" cy="1371600"/>
                <a:chOff x="8793480" y="2636520"/>
                <a:chExt cx="182880" cy="1203960"/>
              </a:xfrm>
            </p:grpSpPr>
            <p:cxnSp>
              <p:nvCxnSpPr>
                <p:cNvPr id="355" name="直線コネクタ 354"/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56" name="直線コネクタ 355"/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57" name="直線コネクタ 356"/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379" name="グループ化 378"/>
            <p:cNvGrpSpPr/>
            <p:nvPr/>
          </p:nvGrpSpPr>
          <p:grpSpPr>
            <a:xfrm>
              <a:off x="1173271" y="2219325"/>
              <a:ext cx="7410500" cy="2397125"/>
              <a:chOff x="1173271" y="2219325"/>
              <a:chExt cx="7410500" cy="2397125"/>
            </a:xfrm>
          </p:grpSpPr>
          <p:grpSp>
            <p:nvGrpSpPr>
              <p:cNvPr id="380" name="グループ化 379"/>
              <p:cNvGrpSpPr/>
              <p:nvPr/>
            </p:nvGrpSpPr>
            <p:grpSpPr>
              <a:xfrm>
                <a:off x="8475771" y="2860675"/>
                <a:ext cx="108000" cy="1755775"/>
                <a:chOff x="8793480" y="2636520"/>
                <a:chExt cx="182880" cy="1203960"/>
              </a:xfrm>
            </p:grpSpPr>
            <p:cxnSp>
              <p:nvCxnSpPr>
                <p:cNvPr id="409" name="直線コネクタ 408"/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10" name="直線コネクタ 409"/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11" name="直線コネクタ 410"/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81" name="グループ化 380"/>
              <p:cNvGrpSpPr/>
              <p:nvPr/>
            </p:nvGrpSpPr>
            <p:grpSpPr>
              <a:xfrm>
                <a:off x="7432555" y="2219325"/>
                <a:ext cx="108000" cy="1889125"/>
                <a:chOff x="8793480" y="2636520"/>
                <a:chExt cx="182880" cy="1203960"/>
              </a:xfrm>
            </p:grpSpPr>
            <p:cxnSp>
              <p:nvCxnSpPr>
                <p:cNvPr id="406" name="直線コネクタ 405"/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07" name="直線コネクタ 406"/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08" name="直線コネクタ 407"/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82" name="グループ化 381"/>
              <p:cNvGrpSpPr/>
              <p:nvPr/>
            </p:nvGrpSpPr>
            <p:grpSpPr>
              <a:xfrm>
                <a:off x="6389341" y="2790826"/>
                <a:ext cx="108000" cy="1671638"/>
                <a:chOff x="8793480" y="2636520"/>
                <a:chExt cx="182880" cy="1203960"/>
              </a:xfrm>
            </p:grpSpPr>
            <p:cxnSp>
              <p:nvCxnSpPr>
                <p:cNvPr id="403" name="直線コネクタ 402"/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04" name="直線コネクタ 403"/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05" name="直線コネクタ 404"/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83" name="グループ化 382"/>
              <p:cNvGrpSpPr/>
              <p:nvPr/>
            </p:nvGrpSpPr>
            <p:grpSpPr>
              <a:xfrm>
                <a:off x="5346127" y="2333626"/>
                <a:ext cx="108000" cy="1616868"/>
                <a:chOff x="8793480" y="2636520"/>
                <a:chExt cx="182880" cy="1203960"/>
              </a:xfrm>
            </p:grpSpPr>
            <p:cxnSp>
              <p:nvCxnSpPr>
                <p:cNvPr id="400" name="直線コネクタ 399"/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01" name="直線コネクタ 400"/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02" name="直線コネクタ 401"/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84" name="グループ化 383"/>
              <p:cNvGrpSpPr/>
              <p:nvPr/>
            </p:nvGrpSpPr>
            <p:grpSpPr>
              <a:xfrm>
                <a:off x="4302913" y="2826544"/>
                <a:ext cx="108000" cy="1583531"/>
                <a:chOff x="8793480" y="2636520"/>
                <a:chExt cx="182880" cy="1203960"/>
              </a:xfrm>
            </p:grpSpPr>
            <p:cxnSp>
              <p:nvCxnSpPr>
                <p:cNvPr id="397" name="直線コネクタ 396"/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8" name="直線コネクタ 397"/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9" name="直線コネクタ 398"/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85" name="グループ化 384"/>
              <p:cNvGrpSpPr/>
              <p:nvPr/>
            </p:nvGrpSpPr>
            <p:grpSpPr>
              <a:xfrm>
                <a:off x="3259699" y="2235200"/>
                <a:ext cx="108000" cy="1647825"/>
                <a:chOff x="8793480" y="2636520"/>
                <a:chExt cx="182880" cy="1203960"/>
              </a:xfrm>
            </p:grpSpPr>
            <p:cxnSp>
              <p:nvCxnSpPr>
                <p:cNvPr id="394" name="直線コネクタ 393"/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5" name="直線コネクタ 394"/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6" name="直線コネクタ 395"/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86" name="グループ化 385"/>
              <p:cNvGrpSpPr/>
              <p:nvPr/>
            </p:nvGrpSpPr>
            <p:grpSpPr>
              <a:xfrm>
                <a:off x="2216485" y="2286000"/>
                <a:ext cx="108000" cy="1647825"/>
                <a:chOff x="8793480" y="2636520"/>
                <a:chExt cx="182880" cy="1203960"/>
              </a:xfrm>
            </p:grpSpPr>
            <p:cxnSp>
              <p:nvCxnSpPr>
                <p:cNvPr id="391" name="直線コネクタ 390"/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2" name="直線コネクタ 391"/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3" name="直線コネクタ 392"/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87" name="グループ化 386"/>
              <p:cNvGrpSpPr/>
              <p:nvPr/>
            </p:nvGrpSpPr>
            <p:grpSpPr>
              <a:xfrm>
                <a:off x="1173271" y="3112294"/>
                <a:ext cx="108000" cy="1276350"/>
                <a:chOff x="8793480" y="2636520"/>
                <a:chExt cx="182880" cy="1203960"/>
              </a:xfrm>
            </p:grpSpPr>
            <p:cxnSp>
              <p:nvCxnSpPr>
                <p:cNvPr id="388" name="直線コネクタ 387"/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89" name="直線コネクタ 388"/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0" name="直線コネクタ 389"/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412" name="グループ化 411"/>
            <p:cNvGrpSpPr/>
            <p:nvPr/>
          </p:nvGrpSpPr>
          <p:grpSpPr>
            <a:xfrm>
              <a:off x="1173271" y="2041525"/>
              <a:ext cx="7410500" cy="2384425"/>
              <a:chOff x="1173271" y="2041525"/>
              <a:chExt cx="7410500" cy="2384425"/>
            </a:xfrm>
          </p:grpSpPr>
          <p:grpSp>
            <p:nvGrpSpPr>
              <p:cNvPr id="413" name="グループ化 412"/>
              <p:cNvGrpSpPr/>
              <p:nvPr/>
            </p:nvGrpSpPr>
            <p:grpSpPr>
              <a:xfrm>
                <a:off x="8475771" y="2651125"/>
                <a:ext cx="108000" cy="1774825"/>
                <a:chOff x="8793480" y="2636520"/>
                <a:chExt cx="182880" cy="1203960"/>
              </a:xfrm>
            </p:grpSpPr>
            <p:cxnSp>
              <p:nvCxnSpPr>
                <p:cNvPr id="442" name="直線コネクタ 441"/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3" name="直線コネクタ 442"/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4" name="直線コネクタ 443"/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14" name="グループ化 413"/>
              <p:cNvGrpSpPr/>
              <p:nvPr/>
            </p:nvGrpSpPr>
            <p:grpSpPr>
              <a:xfrm>
                <a:off x="7432555" y="2476500"/>
                <a:ext cx="108000" cy="1406525"/>
                <a:chOff x="8793480" y="2636520"/>
                <a:chExt cx="182880" cy="1203960"/>
              </a:xfrm>
            </p:grpSpPr>
            <p:cxnSp>
              <p:nvCxnSpPr>
                <p:cNvPr id="439" name="直線コネクタ 438"/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0" name="直線コネクタ 439"/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1" name="直線コネクタ 440"/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15" name="グループ化 414"/>
              <p:cNvGrpSpPr/>
              <p:nvPr/>
            </p:nvGrpSpPr>
            <p:grpSpPr>
              <a:xfrm>
                <a:off x="6389341" y="2825750"/>
                <a:ext cx="108000" cy="1581150"/>
                <a:chOff x="8793480" y="2636520"/>
                <a:chExt cx="182880" cy="1203960"/>
              </a:xfrm>
            </p:grpSpPr>
            <p:cxnSp>
              <p:nvCxnSpPr>
                <p:cNvPr id="436" name="直線コネクタ 435"/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37" name="直線コネクタ 436"/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38" name="直線コネクタ 437"/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16" name="グループ化 415"/>
              <p:cNvGrpSpPr/>
              <p:nvPr/>
            </p:nvGrpSpPr>
            <p:grpSpPr>
              <a:xfrm>
                <a:off x="5346127" y="2387600"/>
                <a:ext cx="108000" cy="1441450"/>
                <a:chOff x="8793480" y="2636520"/>
                <a:chExt cx="182880" cy="1203960"/>
              </a:xfrm>
            </p:grpSpPr>
            <p:cxnSp>
              <p:nvCxnSpPr>
                <p:cNvPr id="433" name="直線コネクタ 432"/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34" name="直線コネクタ 433"/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35" name="直線コネクタ 434"/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17" name="グループ化 416"/>
              <p:cNvGrpSpPr/>
              <p:nvPr/>
            </p:nvGrpSpPr>
            <p:grpSpPr>
              <a:xfrm>
                <a:off x="4302913" y="2569369"/>
                <a:ext cx="108000" cy="1678781"/>
                <a:chOff x="8793480" y="2636520"/>
                <a:chExt cx="182880" cy="1203960"/>
              </a:xfrm>
            </p:grpSpPr>
            <p:cxnSp>
              <p:nvCxnSpPr>
                <p:cNvPr id="430" name="直線コネクタ 429"/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31" name="直線コネクタ 430"/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32" name="直線コネクタ 431"/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18" name="グループ化 417"/>
              <p:cNvGrpSpPr/>
              <p:nvPr/>
            </p:nvGrpSpPr>
            <p:grpSpPr>
              <a:xfrm>
                <a:off x="3259699" y="2041525"/>
                <a:ext cx="108000" cy="1539875"/>
                <a:chOff x="8793480" y="2636520"/>
                <a:chExt cx="182880" cy="1203960"/>
              </a:xfrm>
            </p:grpSpPr>
            <p:cxnSp>
              <p:nvCxnSpPr>
                <p:cNvPr id="427" name="直線コネクタ 426"/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28" name="直線コネクタ 427"/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29" name="直線コネクタ 428"/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19" name="グループ化 418"/>
              <p:cNvGrpSpPr/>
              <p:nvPr/>
            </p:nvGrpSpPr>
            <p:grpSpPr>
              <a:xfrm>
                <a:off x="2216485" y="2147889"/>
                <a:ext cx="108000" cy="1540668"/>
                <a:chOff x="8793480" y="2636520"/>
                <a:chExt cx="182880" cy="1203960"/>
              </a:xfrm>
            </p:grpSpPr>
            <p:cxnSp>
              <p:nvCxnSpPr>
                <p:cNvPr id="424" name="直線コネクタ 423"/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25" name="直線コネクタ 424"/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26" name="直線コネクタ 425"/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20" name="グループ化 419"/>
              <p:cNvGrpSpPr/>
              <p:nvPr/>
            </p:nvGrpSpPr>
            <p:grpSpPr>
              <a:xfrm>
                <a:off x="1173271" y="2914651"/>
                <a:ext cx="108000" cy="1440655"/>
                <a:chOff x="8793480" y="2636520"/>
                <a:chExt cx="182880" cy="1203960"/>
              </a:xfrm>
            </p:grpSpPr>
            <p:cxnSp>
              <p:nvCxnSpPr>
                <p:cNvPr id="421" name="直線コネクタ 420"/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22" name="直線コネクタ 421"/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23" name="直線コネクタ 422"/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445" name="グループ化 444"/>
            <p:cNvGrpSpPr/>
            <p:nvPr/>
          </p:nvGrpSpPr>
          <p:grpSpPr>
            <a:xfrm>
              <a:off x="1173271" y="2459831"/>
              <a:ext cx="7410500" cy="2159793"/>
              <a:chOff x="1173271" y="2459831"/>
              <a:chExt cx="7410500" cy="2159793"/>
            </a:xfrm>
          </p:grpSpPr>
          <p:grpSp>
            <p:nvGrpSpPr>
              <p:cNvPr id="446" name="グループ化 445"/>
              <p:cNvGrpSpPr/>
              <p:nvPr/>
            </p:nvGrpSpPr>
            <p:grpSpPr>
              <a:xfrm>
                <a:off x="8475771" y="2940049"/>
                <a:ext cx="108000" cy="1679575"/>
                <a:chOff x="8793480" y="2636520"/>
                <a:chExt cx="182880" cy="1203960"/>
              </a:xfrm>
            </p:grpSpPr>
            <p:cxnSp>
              <p:nvCxnSpPr>
                <p:cNvPr id="475" name="直線コネクタ 474"/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6" name="直線コネクタ 475"/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7" name="直線コネクタ 476"/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47" name="グループ化 446"/>
              <p:cNvGrpSpPr/>
              <p:nvPr/>
            </p:nvGrpSpPr>
            <p:grpSpPr>
              <a:xfrm>
                <a:off x="7432555" y="2755106"/>
                <a:ext cx="108000" cy="1373982"/>
                <a:chOff x="8793480" y="2636520"/>
                <a:chExt cx="182880" cy="1203960"/>
              </a:xfrm>
            </p:grpSpPr>
            <p:cxnSp>
              <p:nvCxnSpPr>
                <p:cNvPr id="472" name="直線コネクタ 471"/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3" name="直線コネクタ 472"/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4" name="直線コネクタ 473"/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48" name="グループ化 447"/>
              <p:cNvGrpSpPr/>
              <p:nvPr/>
            </p:nvGrpSpPr>
            <p:grpSpPr>
              <a:xfrm>
                <a:off x="6389341" y="3164680"/>
                <a:ext cx="108000" cy="1362076"/>
                <a:chOff x="8793480" y="2636520"/>
                <a:chExt cx="182880" cy="1203960"/>
              </a:xfrm>
            </p:grpSpPr>
            <p:cxnSp>
              <p:nvCxnSpPr>
                <p:cNvPr id="469" name="直線コネクタ 468"/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0" name="直線コネクタ 469"/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1" name="直線コネクタ 470"/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49" name="グループ化 448"/>
              <p:cNvGrpSpPr/>
              <p:nvPr/>
            </p:nvGrpSpPr>
            <p:grpSpPr>
              <a:xfrm>
                <a:off x="5346127" y="2619374"/>
                <a:ext cx="108000" cy="1507332"/>
                <a:chOff x="8793480" y="2636520"/>
                <a:chExt cx="182880" cy="1203960"/>
              </a:xfrm>
            </p:grpSpPr>
            <p:cxnSp>
              <p:nvCxnSpPr>
                <p:cNvPr id="466" name="直線コネクタ 465"/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7" name="直線コネクタ 466"/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8" name="直線コネクタ 467"/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50" name="グループ化 449"/>
              <p:cNvGrpSpPr/>
              <p:nvPr/>
            </p:nvGrpSpPr>
            <p:grpSpPr>
              <a:xfrm>
                <a:off x="4302913" y="2931318"/>
                <a:ext cx="108000" cy="1597819"/>
                <a:chOff x="8793480" y="2636520"/>
                <a:chExt cx="182880" cy="1203960"/>
              </a:xfrm>
            </p:grpSpPr>
            <p:cxnSp>
              <p:nvCxnSpPr>
                <p:cNvPr id="463" name="直線コネクタ 462"/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4" name="直線コネクタ 463"/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5" name="直線コネクタ 464"/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51" name="グループ化 450"/>
              <p:cNvGrpSpPr/>
              <p:nvPr/>
            </p:nvGrpSpPr>
            <p:grpSpPr>
              <a:xfrm>
                <a:off x="3259699" y="2459831"/>
                <a:ext cx="108000" cy="1564482"/>
                <a:chOff x="8793480" y="2636520"/>
                <a:chExt cx="182880" cy="1203960"/>
              </a:xfrm>
            </p:grpSpPr>
            <p:cxnSp>
              <p:nvCxnSpPr>
                <p:cNvPr id="460" name="直線コネクタ 459"/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1" name="直線コネクタ 460"/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2" name="直線コネクタ 461"/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52" name="グループ化 451"/>
              <p:cNvGrpSpPr/>
              <p:nvPr/>
            </p:nvGrpSpPr>
            <p:grpSpPr>
              <a:xfrm>
                <a:off x="2216485" y="2478881"/>
                <a:ext cx="108000" cy="1543050"/>
                <a:chOff x="8793480" y="2636520"/>
                <a:chExt cx="182880" cy="1203960"/>
              </a:xfrm>
            </p:grpSpPr>
            <p:cxnSp>
              <p:nvCxnSpPr>
                <p:cNvPr id="457" name="直線コネクタ 456"/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58" name="直線コネクタ 457"/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59" name="直線コネクタ 458"/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53" name="グループ化 452"/>
              <p:cNvGrpSpPr/>
              <p:nvPr/>
            </p:nvGrpSpPr>
            <p:grpSpPr>
              <a:xfrm>
                <a:off x="1173271" y="3052763"/>
                <a:ext cx="108000" cy="1423987"/>
                <a:chOff x="8793480" y="2636520"/>
                <a:chExt cx="182880" cy="1203960"/>
              </a:xfrm>
            </p:grpSpPr>
            <p:cxnSp>
              <p:nvCxnSpPr>
                <p:cNvPr id="454" name="直線コネクタ 453"/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55" name="直線コネクタ 454"/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56" name="直線コネクタ 455"/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478" name="グループ化 477"/>
            <p:cNvGrpSpPr/>
            <p:nvPr/>
          </p:nvGrpSpPr>
          <p:grpSpPr>
            <a:xfrm>
              <a:off x="1173271" y="2706688"/>
              <a:ext cx="7410500" cy="2346325"/>
              <a:chOff x="1173271" y="2706688"/>
              <a:chExt cx="7410500" cy="2346325"/>
            </a:xfrm>
          </p:grpSpPr>
          <p:grpSp>
            <p:nvGrpSpPr>
              <p:cNvPr id="479" name="グループ化 478"/>
              <p:cNvGrpSpPr/>
              <p:nvPr/>
            </p:nvGrpSpPr>
            <p:grpSpPr>
              <a:xfrm>
                <a:off x="8475771" y="3302001"/>
                <a:ext cx="108000" cy="1751012"/>
                <a:chOff x="8793480" y="2636520"/>
                <a:chExt cx="182880" cy="1203960"/>
              </a:xfrm>
            </p:grpSpPr>
            <p:cxnSp>
              <p:nvCxnSpPr>
                <p:cNvPr id="508" name="直線コネクタ 507"/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09" name="直線コネクタ 508"/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10" name="直線コネクタ 509"/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80" name="グループ化 479"/>
              <p:cNvGrpSpPr/>
              <p:nvPr/>
            </p:nvGrpSpPr>
            <p:grpSpPr>
              <a:xfrm>
                <a:off x="7432555" y="2947989"/>
                <a:ext cx="108000" cy="1655762"/>
                <a:chOff x="8793480" y="2636520"/>
                <a:chExt cx="182880" cy="1203960"/>
              </a:xfrm>
            </p:grpSpPr>
            <p:cxnSp>
              <p:nvCxnSpPr>
                <p:cNvPr id="505" name="直線コネクタ 504"/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06" name="直線コネクタ 505"/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07" name="直線コネクタ 506"/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81" name="グループ化 480"/>
              <p:cNvGrpSpPr/>
              <p:nvPr/>
            </p:nvGrpSpPr>
            <p:grpSpPr>
              <a:xfrm>
                <a:off x="6389341" y="3250406"/>
                <a:ext cx="108000" cy="1702594"/>
                <a:chOff x="8793480" y="2636520"/>
                <a:chExt cx="182880" cy="1203960"/>
              </a:xfrm>
            </p:grpSpPr>
            <p:cxnSp>
              <p:nvCxnSpPr>
                <p:cNvPr id="502" name="直線コネクタ 501"/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03" name="直線コネクタ 502"/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04" name="直線コネクタ 503"/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82" name="グループ化 481"/>
              <p:cNvGrpSpPr/>
              <p:nvPr/>
            </p:nvGrpSpPr>
            <p:grpSpPr>
              <a:xfrm>
                <a:off x="5346127" y="2759869"/>
                <a:ext cx="108000" cy="1824037"/>
                <a:chOff x="8793480" y="2636520"/>
                <a:chExt cx="182880" cy="1203960"/>
              </a:xfrm>
            </p:grpSpPr>
            <p:cxnSp>
              <p:nvCxnSpPr>
                <p:cNvPr id="499" name="直線コネクタ 498"/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00" name="直線コネクタ 499"/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01" name="直線コネクタ 500"/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83" name="グループ化 482"/>
              <p:cNvGrpSpPr/>
              <p:nvPr/>
            </p:nvGrpSpPr>
            <p:grpSpPr>
              <a:xfrm>
                <a:off x="4302913" y="3162300"/>
                <a:ext cx="108000" cy="1562099"/>
                <a:chOff x="8793480" y="2636520"/>
                <a:chExt cx="182880" cy="1203960"/>
              </a:xfrm>
            </p:grpSpPr>
            <p:cxnSp>
              <p:nvCxnSpPr>
                <p:cNvPr id="496" name="直線コネクタ 495"/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97" name="直線コネクタ 496"/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98" name="直線コネクタ 497"/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84" name="グループ化 483"/>
              <p:cNvGrpSpPr/>
              <p:nvPr/>
            </p:nvGrpSpPr>
            <p:grpSpPr>
              <a:xfrm>
                <a:off x="3259699" y="2706688"/>
                <a:ext cx="108000" cy="1700212"/>
                <a:chOff x="8793480" y="2636520"/>
                <a:chExt cx="182880" cy="1203960"/>
              </a:xfrm>
            </p:grpSpPr>
            <p:cxnSp>
              <p:nvCxnSpPr>
                <p:cNvPr id="493" name="直線コネクタ 492"/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94" name="直線コネクタ 493"/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95" name="直線コネクタ 494"/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85" name="グループ化 484"/>
              <p:cNvGrpSpPr/>
              <p:nvPr/>
            </p:nvGrpSpPr>
            <p:grpSpPr>
              <a:xfrm>
                <a:off x="2216485" y="2797175"/>
                <a:ext cx="108000" cy="1682751"/>
                <a:chOff x="8793480" y="2636520"/>
                <a:chExt cx="182880" cy="1203960"/>
              </a:xfrm>
            </p:grpSpPr>
            <p:cxnSp>
              <p:nvCxnSpPr>
                <p:cNvPr id="490" name="直線コネクタ 489"/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91" name="直線コネクタ 490"/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92" name="直線コネクタ 491"/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86" name="グループ化 485"/>
              <p:cNvGrpSpPr/>
              <p:nvPr/>
            </p:nvGrpSpPr>
            <p:grpSpPr>
              <a:xfrm>
                <a:off x="1173271" y="2867026"/>
                <a:ext cx="108000" cy="1555750"/>
                <a:chOff x="8793480" y="2636520"/>
                <a:chExt cx="182880" cy="1203960"/>
              </a:xfrm>
            </p:grpSpPr>
            <p:cxnSp>
              <p:nvCxnSpPr>
                <p:cNvPr id="487" name="直線コネクタ 486"/>
                <p:cNvCxnSpPr/>
                <p:nvPr/>
              </p:nvCxnSpPr>
              <p:spPr>
                <a:xfrm>
                  <a:off x="8793480" y="263652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8" name="直線コネクタ 487"/>
                <p:cNvCxnSpPr/>
                <p:nvPr/>
              </p:nvCxnSpPr>
              <p:spPr>
                <a:xfrm>
                  <a:off x="8793480" y="3840480"/>
                  <a:ext cx="18288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9" name="直線コネクタ 488"/>
                <p:cNvCxnSpPr/>
                <p:nvPr/>
              </p:nvCxnSpPr>
              <p:spPr>
                <a:xfrm>
                  <a:off x="8884920" y="2636520"/>
                  <a:ext cx="0" cy="120396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511" name="グループ化 510"/>
            <p:cNvGrpSpPr/>
            <p:nvPr/>
          </p:nvGrpSpPr>
          <p:grpSpPr>
            <a:xfrm>
              <a:off x="1173296" y="3519636"/>
              <a:ext cx="7410450" cy="731887"/>
              <a:chOff x="1173296" y="3519636"/>
              <a:chExt cx="7410450" cy="731887"/>
            </a:xfrm>
          </p:grpSpPr>
          <p:grpSp>
            <p:nvGrpSpPr>
              <p:cNvPr id="512" name="グループ化 511"/>
              <p:cNvGrpSpPr/>
              <p:nvPr/>
            </p:nvGrpSpPr>
            <p:grpSpPr>
              <a:xfrm>
                <a:off x="1173296" y="3519636"/>
                <a:ext cx="7410450" cy="731887"/>
                <a:chOff x="1173296" y="3519636"/>
                <a:chExt cx="7410450" cy="731887"/>
              </a:xfrm>
            </p:grpSpPr>
            <p:sp>
              <p:nvSpPr>
                <p:cNvPr id="514" name="ひし形 513"/>
                <p:cNvSpPr/>
                <p:nvPr/>
              </p:nvSpPr>
              <p:spPr>
                <a:xfrm>
                  <a:off x="1173296" y="3580755"/>
                  <a:ext cx="107950" cy="108000"/>
                </a:xfrm>
                <a:prstGeom prst="diamond">
                  <a:avLst/>
                </a:prstGeom>
                <a:solidFill>
                  <a:srgbClr val="7F7F7F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515" name="ひし形 514"/>
                <p:cNvSpPr/>
                <p:nvPr/>
              </p:nvSpPr>
              <p:spPr>
                <a:xfrm>
                  <a:off x="2216510" y="3586311"/>
                  <a:ext cx="107950" cy="108000"/>
                </a:xfrm>
                <a:prstGeom prst="diamond">
                  <a:avLst/>
                </a:prstGeom>
                <a:solidFill>
                  <a:srgbClr val="7F7F7F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516" name="ひし形 515"/>
                <p:cNvSpPr/>
                <p:nvPr/>
              </p:nvSpPr>
              <p:spPr>
                <a:xfrm>
                  <a:off x="3259724" y="3519636"/>
                  <a:ext cx="107950" cy="108000"/>
                </a:xfrm>
                <a:prstGeom prst="diamond">
                  <a:avLst/>
                </a:prstGeom>
                <a:solidFill>
                  <a:srgbClr val="7F7F7F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517" name="ひし形 516"/>
                <p:cNvSpPr/>
                <p:nvPr/>
              </p:nvSpPr>
              <p:spPr>
                <a:xfrm>
                  <a:off x="4302938" y="3891112"/>
                  <a:ext cx="107950" cy="108000"/>
                </a:xfrm>
                <a:prstGeom prst="diamond">
                  <a:avLst/>
                </a:prstGeom>
                <a:solidFill>
                  <a:srgbClr val="7F7F7F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518" name="ひし形 517"/>
                <p:cNvSpPr/>
                <p:nvPr/>
              </p:nvSpPr>
              <p:spPr>
                <a:xfrm>
                  <a:off x="5346152" y="3645842"/>
                  <a:ext cx="107950" cy="108000"/>
                </a:xfrm>
                <a:prstGeom prst="diamond">
                  <a:avLst/>
                </a:prstGeom>
                <a:solidFill>
                  <a:srgbClr val="7F7F7F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519" name="ひし形 518"/>
                <p:cNvSpPr/>
                <p:nvPr/>
              </p:nvSpPr>
              <p:spPr>
                <a:xfrm>
                  <a:off x="6389366" y="4057799"/>
                  <a:ext cx="107950" cy="108000"/>
                </a:xfrm>
                <a:prstGeom prst="diamond">
                  <a:avLst/>
                </a:prstGeom>
                <a:solidFill>
                  <a:srgbClr val="7F7F7F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520" name="ひし形 519"/>
                <p:cNvSpPr/>
                <p:nvPr/>
              </p:nvSpPr>
              <p:spPr>
                <a:xfrm>
                  <a:off x="7432580" y="3745855"/>
                  <a:ext cx="107950" cy="108000"/>
                </a:xfrm>
                <a:prstGeom prst="diamond">
                  <a:avLst/>
                </a:prstGeom>
                <a:solidFill>
                  <a:srgbClr val="7F7F7F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521" name="ひし形 520"/>
                <p:cNvSpPr/>
                <p:nvPr/>
              </p:nvSpPr>
              <p:spPr>
                <a:xfrm>
                  <a:off x="8475796" y="4143523"/>
                  <a:ext cx="107950" cy="108000"/>
                </a:xfrm>
                <a:prstGeom prst="diamond">
                  <a:avLst/>
                </a:prstGeom>
                <a:solidFill>
                  <a:srgbClr val="7F7F7F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513" name="フリーフォーム 512"/>
              <p:cNvSpPr/>
              <p:nvPr/>
            </p:nvSpPr>
            <p:spPr>
              <a:xfrm>
                <a:off x="1219200" y="3566160"/>
                <a:ext cx="7314248" cy="640080"/>
              </a:xfrm>
              <a:custGeom>
                <a:avLst/>
                <a:gdLst>
                  <a:gd name="connsiteX0" fmla="*/ 0 w 7299960"/>
                  <a:gd name="connsiteY0" fmla="*/ 60960 h 640080"/>
                  <a:gd name="connsiteX1" fmla="*/ 1051560 w 7299960"/>
                  <a:gd name="connsiteY1" fmla="*/ 76200 h 640080"/>
                  <a:gd name="connsiteX2" fmla="*/ 2095500 w 7299960"/>
                  <a:gd name="connsiteY2" fmla="*/ 0 h 640080"/>
                  <a:gd name="connsiteX3" fmla="*/ 3139440 w 7299960"/>
                  <a:gd name="connsiteY3" fmla="*/ 381000 h 640080"/>
                  <a:gd name="connsiteX4" fmla="*/ 4183380 w 7299960"/>
                  <a:gd name="connsiteY4" fmla="*/ 129540 h 640080"/>
                  <a:gd name="connsiteX5" fmla="*/ 5219700 w 7299960"/>
                  <a:gd name="connsiteY5" fmla="*/ 548640 h 640080"/>
                  <a:gd name="connsiteX6" fmla="*/ 6263640 w 7299960"/>
                  <a:gd name="connsiteY6" fmla="*/ 228600 h 640080"/>
                  <a:gd name="connsiteX7" fmla="*/ 7299960 w 7299960"/>
                  <a:gd name="connsiteY7" fmla="*/ 640080 h 640080"/>
                  <a:gd name="connsiteX0" fmla="*/ 0 w 7314248"/>
                  <a:gd name="connsiteY0" fmla="*/ 60960 h 640080"/>
                  <a:gd name="connsiteX1" fmla="*/ 1051560 w 7314248"/>
                  <a:gd name="connsiteY1" fmla="*/ 76200 h 640080"/>
                  <a:gd name="connsiteX2" fmla="*/ 2095500 w 7314248"/>
                  <a:gd name="connsiteY2" fmla="*/ 0 h 640080"/>
                  <a:gd name="connsiteX3" fmla="*/ 3139440 w 7314248"/>
                  <a:gd name="connsiteY3" fmla="*/ 381000 h 640080"/>
                  <a:gd name="connsiteX4" fmla="*/ 4183380 w 7314248"/>
                  <a:gd name="connsiteY4" fmla="*/ 129540 h 640080"/>
                  <a:gd name="connsiteX5" fmla="*/ 5219700 w 7314248"/>
                  <a:gd name="connsiteY5" fmla="*/ 548640 h 640080"/>
                  <a:gd name="connsiteX6" fmla="*/ 6263640 w 7314248"/>
                  <a:gd name="connsiteY6" fmla="*/ 228600 h 640080"/>
                  <a:gd name="connsiteX7" fmla="*/ 7314248 w 7314248"/>
                  <a:gd name="connsiteY7" fmla="*/ 640080 h 64008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7314248" h="640080">
                    <a:moveTo>
                      <a:pt x="0" y="60960"/>
                    </a:moveTo>
                    <a:lnTo>
                      <a:pt x="1051560" y="76200"/>
                    </a:lnTo>
                    <a:lnTo>
                      <a:pt x="2095500" y="0"/>
                    </a:lnTo>
                    <a:lnTo>
                      <a:pt x="3139440" y="381000"/>
                    </a:lnTo>
                    <a:lnTo>
                      <a:pt x="4183380" y="129540"/>
                    </a:lnTo>
                    <a:lnTo>
                      <a:pt x="5219700" y="548640"/>
                    </a:lnTo>
                    <a:lnTo>
                      <a:pt x="6263640" y="228600"/>
                    </a:lnTo>
                    <a:lnTo>
                      <a:pt x="7314248" y="640080"/>
                    </a:lnTo>
                  </a:path>
                </a:pathLst>
              </a:custGeom>
              <a:ln w="19050">
                <a:solidFill>
                  <a:srgbClr val="7F7F7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522" name="グループ化 521"/>
            <p:cNvGrpSpPr/>
            <p:nvPr/>
          </p:nvGrpSpPr>
          <p:grpSpPr>
            <a:xfrm>
              <a:off x="1173296" y="3249761"/>
              <a:ext cx="7410450" cy="814437"/>
              <a:chOff x="1173296" y="3249761"/>
              <a:chExt cx="7410450" cy="814437"/>
            </a:xfrm>
          </p:grpSpPr>
          <p:grpSp>
            <p:nvGrpSpPr>
              <p:cNvPr id="523" name="グループ化 522"/>
              <p:cNvGrpSpPr/>
              <p:nvPr/>
            </p:nvGrpSpPr>
            <p:grpSpPr>
              <a:xfrm>
                <a:off x="1173296" y="3249761"/>
                <a:ext cx="7410450" cy="814437"/>
                <a:chOff x="1173296" y="3249761"/>
                <a:chExt cx="7410450" cy="814437"/>
              </a:xfrm>
              <a:solidFill>
                <a:schemeClr val="tx1"/>
              </a:solidFill>
            </p:grpSpPr>
            <p:sp>
              <p:nvSpPr>
                <p:cNvPr id="525" name="ひし形 244"/>
                <p:cNvSpPr/>
                <p:nvPr/>
              </p:nvSpPr>
              <p:spPr>
                <a:xfrm>
                  <a:off x="1173296" y="3774430"/>
                  <a:ext cx="107950" cy="108000"/>
                </a:xfrm>
                <a:prstGeom prst="rect">
                  <a:avLst/>
                </a:prstGeom>
                <a:grp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526" name="ひし形 245"/>
                <p:cNvSpPr/>
                <p:nvPr/>
              </p:nvSpPr>
              <p:spPr>
                <a:xfrm>
                  <a:off x="2216510" y="3249761"/>
                  <a:ext cx="107950" cy="108000"/>
                </a:xfrm>
                <a:prstGeom prst="rect">
                  <a:avLst/>
                </a:prstGeom>
                <a:grp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527" name="ひし形 246"/>
                <p:cNvSpPr/>
                <p:nvPr/>
              </p:nvSpPr>
              <p:spPr>
                <a:xfrm>
                  <a:off x="3259724" y="3297386"/>
                  <a:ext cx="107950" cy="108000"/>
                </a:xfrm>
                <a:prstGeom prst="rect">
                  <a:avLst/>
                </a:prstGeom>
                <a:grp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528" name="ひし形 247"/>
                <p:cNvSpPr/>
                <p:nvPr/>
              </p:nvSpPr>
              <p:spPr>
                <a:xfrm>
                  <a:off x="4302938" y="3838724"/>
                  <a:ext cx="107950" cy="108000"/>
                </a:xfrm>
                <a:prstGeom prst="rect">
                  <a:avLst/>
                </a:prstGeom>
                <a:grp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529" name="ひし形 248"/>
                <p:cNvSpPr/>
                <p:nvPr/>
              </p:nvSpPr>
              <p:spPr>
                <a:xfrm>
                  <a:off x="5346152" y="3407717"/>
                  <a:ext cx="107950" cy="108000"/>
                </a:xfrm>
                <a:prstGeom prst="rect">
                  <a:avLst/>
                </a:prstGeom>
                <a:grp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530" name="ひし形 249"/>
                <p:cNvSpPr/>
                <p:nvPr/>
              </p:nvSpPr>
              <p:spPr>
                <a:xfrm>
                  <a:off x="6389366" y="3774430"/>
                  <a:ext cx="107950" cy="108000"/>
                </a:xfrm>
                <a:prstGeom prst="rect">
                  <a:avLst/>
                </a:prstGeom>
                <a:grp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531" name="ひし形 250"/>
                <p:cNvSpPr/>
                <p:nvPr/>
              </p:nvSpPr>
              <p:spPr>
                <a:xfrm>
                  <a:off x="7432580" y="3500587"/>
                  <a:ext cx="107950" cy="108000"/>
                </a:xfrm>
                <a:prstGeom prst="rect">
                  <a:avLst/>
                </a:prstGeom>
                <a:grp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532" name="ひし形 251"/>
                <p:cNvSpPr/>
                <p:nvPr/>
              </p:nvSpPr>
              <p:spPr>
                <a:xfrm>
                  <a:off x="8475796" y="3956198"/>
                  <a:ext cx="107950" cy="108000"/>
                </a:xfrm>
                <a:prstGeom prst="rect">
                  <a:avLst/>
                </a:prstGeom>
                <a:grp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524" name="フリーフォーム 523"/>
              <p:cNvSpPr/>
              <p:nvPr/>
            </p:nvSpPr>
            <p:spPr>
              <a:xfrm>
                <a:off x="1219200" y="3299460"/>
                <a:ext cx="7299960" cy="701040"/>
              </a:xfrm>
              <a:custGeom>
                <a:avLst/>
                <a:gdLst>
                  <a:gd name="connsiteX0" fmla="*/ 0 w 7299960"/>
                  <a:gd name="connsiteY0" fmla="*/ 525780 h 701040"/>
                  <a:gd name="connsiteX1" fmla="*/ 1051560 w 7299960"/>
                  <a:gd name="connsiteY1" fmla="*/ 0 h 701040"/>
                  <a:gd name="connsiteX2" fmla="*/ 2095500 w 7299960"/>
                  <a:gd name="connsiteY2" fmla="*/ 53340 h 701040"/>
                  <a:gd name="connsiteX3" fmla="*/ 3139440 w 7299960"/>
                  <a:gd name="connsiteY3" fmla="*/ 594360 h 701040"/>
                  <a:gd name="connsiteX4" fmla="*/ 4183380 w 7299960"/>
                  <a:gd name="connsiteY4" fmla="*/ 160020 h 701040"/>
                  <a:gd name="connsiteX5" fmla="*/ 5219700 w 7299960"/>
                  <a:gd name="connsiteY5" fmla="*/ 533400 h 701040"/>
                  <a:gd name="connsiteX6" fmla="*/ 6263640 w 7299960"/>
                  <a:gd name="connsiteY6" fmla="*/ 251460 h 701040"/>
                  <a:gd name="connsiteX7" fmla="*/ 7299960 w 7299960"/>
                  <a:gd name="connsiteY7" fmla="*/ 701040 h 70104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7299960" h="701040">
                    <a:moveTo>
                      <a:pt x="0" y="525780"/>
                    </a:moveTo>
                    <a:lnTo>
                      <a:pt x="1051560" y="0"/>
                    </a:lnTo>
                    <a:lnTo>
                      <a:pt x="2095500" y="53340"/>
                    </a:lnTo>
                    <a:lnTo>
                      <a:pt x="3139440" y="594360"/>
                    </a:lnTo>
                    <a:lnTo>
                      <a:pt x="4183380" y="160020"/>
                    </a:lnTo>
                    <a:lnTo>
                      <a:pt x="5219700" y="533400"/>
                    </a:lnTo>
                    <a:lnTo>
                      <a:pt x="6263640" y="251460"/>
                    </a:lnTo>
                    <a:lnTo>
                      <a:pt x="7299960" y="701040"/>
                    </a:lnTo>
                  </a:path>
                </a:pathLst>
              </a:cu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533" name="グループ化 532"/>
            <p:cNvGrpSpPr/>
            <p:nvPr/>
          </p:nvGrpSpPr>
          <p:grpSpPr>
            <a:xfrm>
              <a:off x="1173296" y="2998936"/>
              <a:ext cx="7410450" cy="796180"/>
              <a:chOff x="1173296" y="2998936"/>
              <a:chExt cx="7410450" cy="796180"/>
            </a:xfrm>
          </p:grpSpPr>
          <p:grpSp>
            <p:nvGrpSpPr>
              <p:cNvPr id="534" name="グループ化 533"/>
              <p:cNvGrpSpPr/>
              <p:nvPr/>
            </p:nvGrpSpPr>
            <p:grpSpPr>
              <a:xfrm>
                <a:off x="1173296" y="2998936"/>
                <a:ext cx="7410450" cy="796180"/>
                <a:chOff x="1173296" y="2998936"/>
                <a:chExt cx="7410450" cy="796180"/>
              </a:xfrm>
              <a:solidFill>
                <a:schemeClr val="tx1"/>
              </a:solidFill>
            </p:grpSpPr>
            <p:sp>
              <p:nvSpPr>
                <p:cNvPr id="536" name="ひし形 244"/>
                <p:cNvSpPr/>
                <p:nvPr/>
              </p:nvSpPr>
              <p:spPr>
                <a:xfrm>
                  <a:off x="1173296" y="3683943"/>
                  <a:ext cx="107950" cy="108000"/>
                </a:xfrm>
                <a:prstGeom prst="triangle">
                  <a:avLst/>
                </a:prstGeom>
                <a:grp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537" name="ひし形 245"/>
                <p:cNvSpPr/>
                <p:nvPr/>
              </p:nvSpPr>
              <p:spPr>
                <a:xfrm>
                  <a:off x="2216510" y="3054499"/>
                  <a:ext cx="107950" cy="108000"/>
                </a:xfrm>
                <a:prstGeom prst="triangle">
                  <a:avLst/>
                </a:prstGeom>
                <a:grp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538" name="ひし形 246"/>
                <p:cNvSpPr/>
                <p:nvPr/>
              </p:nvSpPr>
              <p:spPr>
                <a:xfrm>
                  <a:off x="3259724" y="2998936"/>
                  <a:ext cx="107950" cy="108000"/>
                </a:xfrm>
                <a:prstGeom prst="triangle">
                  <a:avLst/>
                </a:prstGeom>
                <a:grp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539" name="ひし形 247"/>
                <p:cNvSpPr/>
                <p:nvPr/>
              </p:nvSpPr>
              <p:spPr>
                <a:xfrm>
                  <a:off x="4302938" y="3581549"/>
                  <a:ext cx="107950" cy="108000"/>
                </a:xfrm>
                <a:prstGeom prst="triangle">
                  <a:avLst/>
                </a:prstGeom>
                <a:grp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540" name="ひし形 248"/>
                <p:cNvSpPr/>
                <p:nvPr/>
              </p:nvSpPr>
              <p:spPr>
                <a:xfrm>
                  <a:off x="5346152" y="3114823"/>
                  <a:ext cx="107950" cy="108000"/>
                </a:xfrm>
                <a:prstGeom prst="triangle">
                  <a:avLst/>
                </a:prstGeom>
                <a:grp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541" name="ひし形 249"/>
                <p:cNvSpPr/>
                <p:nvPr/>
              </p:nvSpPr>
              <p:spPr>
                <a:xfrm>
                  <a:off x="6389366" y="3567262"/>
                  <a:ext cx="107950" cy="108000"/>
                </a:xfrm>
                <a:prstGeom prst="triangle">
                  <a:avLst/>
                </a:prstGeom>
                <a:grp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542" name="ひし形 250"/>
                <p:cNvSpPr/>
                <p:nvPr/>
              </p:nvSpPr>
              <p:spPr>
                <a:xfrm>
                  <a:off x="7432580" y="3105299"/>
                  <a:ext cx="107950" cy="108000"/>
                </a:xfrm>
                <a:prstGeom prst="triangle">
                  <a:avLst/>
                </a:prstGeom>
                <a:grp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543" name="ひし形 251"/>
                <p:cNvSpPr/>
                <p:nvPr/>
              </p:nvSpPr>
              <p:spPr>
                <a:xfrm>
                  <a:off x="8475796" y="3687116"/>
                  <a:ext cx="107950" cy="108000"/>
                </a:xfrm>
                <a:prstGeom prst="triangle">
                  <a:avLst/>
                </a:prstGeom>
                <a:grp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535" name="フリーフォーム 534"/>
              <p:cNvSpPr/>
              <p:nvPr/>
            </p:nvSpPr>
            <p:spPr>
              <a:xfrm>
                <a:off x="1219200" y="3055620"/>
                <a:ext cx="7307580" cy="693420"/>
              </a:xfrm>
              <a:custGeom>
                <a:avLst/>
                <a:gdLst>
                  <a:gd name="connsiteX0" fmla="*/ 0 w 7307580"/>
                  <a:gd name="connsiteY0" fmla="*/ 685800 h 693420"/>
                  <a:gd name="connsiteX1" fmla="*/ 1051560 w 7307580"/>
                  <a:gd name="connsiteY1" fmla="*/ 53340 h 693420"/>
                  <a:gd name="connsiteX2" fmla="*/ 2095500 w 7307580"/>
                  <a:gd name="connsiteY2" fmla="*/ 0 h 693420"/>
                  <a:gd name="connsiteX3" fmla="*/ 3139440 w 7307580"/>
                  <a:gd name="connsiteY3" fmla="*/ 586740 h 693420"/>
                  <a:gd name="connsiteX4" fmla="*/ 4175760 w 7307580"/>
                  <a:gd name="connsiteY4" fmla="*/ 114300 h 693420"/>
                  <a:gd name="connsiteX5" fmla="*/ 5219700 w 7307580"/>
                  <a:gd name="connsiteY5" fmla="*/ 571500 h 693420"/>
                  <a:gd name="connsiteX6" fmla="*/ 6271260 w 7307580"/>
                  <a:gd name="connsiteY6" fmla="*/ 106680 h 693420"/>
                  <a:gd name="connsiteX7" fmla="*/ 7307580 w 7307580"/>
                  <a:gd name="connsiteY7" fmla="*/ 693420 h 69342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7307580" h="693420">
                    <a:moveTo>
                      <a:pt x="0" y="685800"/>
                    </a:moveTo>
                    <a:lnTo>
                      <a:pt x="1051560" y="53340"/>
                    </a:lnTo>
                    <a:lnTo>
                      <a:pt x="2095500" y="0"/>
                    </a:lnTo>
                    <a:lnTo>
                      <a:pt x="3139440" y="586740"/>
                    </a:lnTo>
                    <a:lnTo>
                      <a:pt x="4175760" y="114300"/>
                    </a:lnTo>
                    <a:lnTo>
                      <a:pt x="5219700" y="571500"/>
                    </a:lnTo>
                    <a:lnTo>
                      <a:pt x="6271260" y="106680"/>
                    </a:lnTo>
                    <a:lnTo>
                      <a:pt x="7307580" y="693420"/>
                    </a:lnTo>
                  </a:path>
                </a:pathLst>
              </a:custGeom>
              <a:noFill/>
              <a:ln w="19050"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544" name="グループ化 543"/>
            <p:cNvGrpSpPr/>
            <p:nvPr/>
          </p:nvGrpSpPr>
          <p:grpSpPr>
            <a:xfrm>
              <a:off x="1173296" y="3221187"/>
              <a:ext cx="7410450" cy="701725"/>
              <a:chOff x="1173296" y="3221187"/>
              <a:chExt cx="7410450" cy="701725"/>
            </a:xfrm>
          </p:grpSpPr>
          <p:grpSp>
            <p:nvGrpSpPr>
              <p:cNvPr id="545" name="グループ化 544"/>
              <p:cNvGrpSpPr/>
              <p:nvPr/>
            </p:nvGrpSpPr>
            <p:grpSpPr>
              <a:xfrm>
                <a:off x="1173296" y="3221187"/>
                <a:ext cx="7410450" cy="701725"/>
                <a:chOff x="1173296" y="3221187"/>
                <a:chExt cx="7410450" cy="701725"/>
              </a:xfrm>
            </p:grpSpPr>
            <p:sp>
              <p:nvSpPr>
                <p:cNvPr id="547" name="ひし形 244"/>
                <p:cNvSpPr/>
                <p:nvPr/>
              </p:nvSpPr>
              <p:spPr>
                <a:xfrm>
                  <a:off x="1173296" y="3764906"/>
                  <a:ext cx="107950" cy="108000"/>
                </a:xfrm>
                <a:prstGeom prst="ellipse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548" name="ひし形 245"/>
                <p:cNvSpPr/>
                <p:nvPr/>
              </p:nvSpPr>
              <p:spPr>
                <a:xfrm>
                  <a:off x="2216510" y="3221187"/>
                  <a:ext cx="107950" cy="108000"/>
                </a:xfrm>
                <a:prstGeom prst="ellipse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549" name="ひし形 246"/>
                <p:cNvSpPr/>
                <p:nvPr/>
              </p:nvSpPr>
              <p:spPr>
                <a:xfrm>
                  <a:off x="3259724" y="3221187"/>
                  <a:ext cx="107950" cy="108000"/>
                </a:xfrm>
                <a:prstGeom prst="ellipse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550" name="ひし形 247"/>
                <p:cNvSpPr/>
                <p:nvPr/>
              </p:nvSpPr>
              <p:spPr>
                <a:xfrm>
                  <a:off x="4302938" y="3698230"/>
                  <a:ext cx="107950" cy="108000"/>
                </a:xfrm>
                <a:prstGeom prst="ellipse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551" name="ひし形 248"/>
                <p:cNvSpPr/>
                <p:nvPr/>
              </p:nvSpPr>
              <p:spPr>
                <a:xfrm>
                  <a:off x="5346152" y="3357710"/>
                  <a:ext cx="107950" cy="108000"/>
                </a:xfrm>
                <a:prstGeom prst="ellipse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552" name="ひし形 249"/>
                <p:cNvSpPr/>
                <p:nvPr/>
              </p:nvSpPr>
              <p:spPr>
                <a:xfrm>
                  <a:off x="6389366" y="3814912"/>
                  <a:ext cx="107950" cy="108000"/>
                </a:xfrm>
                <a:prstGeom prst="ellipse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553" name="ひし形 250"/>
                <p:cNvSpPr/>
                <p:nvPr/>
              </p:nvSpPr>
              <p:spPr>
                <a:xfrm>
                  <a:off x="7432580" y="3422006"/>
                  <a:ext cx="107950" cy="108000"/>
                </a:xfrm>
                <a:prstGeom prst="ellipse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554" name="ひし形 251"/>
                <p:cNvSpPr/>
                <p:nvPr/>
              </p:nvSpPr>
              <p:spPr>
                <a:xfrm>
                  <a:off x="8475796" y="3756966"/>
                  <a:ext cx="107950" cy="108000"/>
                </a:xfrm>
                <a:prstGeom prst="ellipse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546" name="フリーフォーム 545"/>
              <p:cNvSpPr/>
              <p:nvPr/>
            </p:nvSpPr>
            <p:spPr>
              <a:xfrm>
                <a:off x="1211580" y="3268980"/>
                <a:ext cx="7315200" cy="609600"/>
              </a:xfrm>
              <a:custGeom>
                <a:avLst/>
                <a:gdLst>
                  <a:gd name="connsiteX0" fmla="*/ 0 w 7315200"/>
                  <a:gd name="connsiteY0" fmla="*/ 541020 h 609600"/>
                  <a:gd name="connsiteX1" fmla="*/ 1051560 w 7315200"/>
                  <a:gd name="connsiteY1" fmla="*/ 0 h 609600"/>
                  <a:gd name="connsiteX2" fmla="*/ 2095500 w 7315200"/>
                  <a:gd name="connsiteY2" fmla="*/ 0 h 609600"/>
                  <a:gd name="connsiteX3" fmla="*/ 3147060 w 7315200"/>
                  <a:gd name="connsiteY3" fmla="*/ 480060 h 609600"/>
                  <a:gd name="connsiteX4" fmla="*/ 4191000 w 7315200"/>
                  <a:gd name="connsiteY4" fmla="*/ 144780 h 609600"/>
                  <a:gd name="connsiteX5" fmla="*/ 5227320 w 7315200"/>
                  <a:gd name="connsiteY5" fmla="*/ 609600 h 609600"/>
                  <a:gd name="connsiteX6" fmla="*/ 6271260 w 7315200"/>
                  <a:gd name="connsiteY6" fmla="*/ 205740 h 609600"/>
                  <a:gd name="connsiteX7" fmla="*/ 7315200 w 7315200"/>
                  <a:gd name="connsiteY7" fmla="*/ 541020 h 6096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7315200" h="609600">
                    <a:moveTo>
                      <a:pt x="0" y="541020"/>
                    </a:moveTo>
                    <a:lnTo>
                      <a:pt x="1051560" y="0"/>
                    </a:lnTo>
                    <a:lnTo>
                      <a:pt x="2095500" y="0"/>
                    </a:lnTo>
                    <a:lnTo>
                      <a:pt x="3147060" y="480060"/>
                    </a:lnTo>
                    <a:lnTo>
                      <a:pt x="4191000" y="144780"/>
                    </a:lnTo>
                    <a:lnTo>
                      <a:pt x="5227320" y="609600"/>
                    </a:lnTo>
                    <a:lnTo>
                      <a:pt x="6271260" y="205740"/>
                    </a:lnTo>
                    <a:lnTo>
                      <a:pt x="7315200" y="541020"/>
                    </a:lnTo>
                  </a:path>
                </a:pathLst>
              </a:custGeom>
              <a:noFill/>
              <a:ln w="19050">
                <a:solidFill>
                  <a:schemeClr val="tx1"/>
                </a:solidFill>
                <a:prstDash val="lgDashDot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555" name="グループ化 554"/>
            <p:cNvGrpSpPr/>
            <p:nvPr/>
          </p:nvGrpSpPr>
          <p:grpSpPr>
            <a:xfrm>
              <a:off x="1155271" y="2754456"/>
              <a:ext cx="7446500" cy="963944"/>
              <a:chOff x="1155271" y="2754456"/>
              <a:chExt cx="7446500" cy="963944"/>
            </a:xfrm>
          </p:grpSpPr>
          <p:grpSp>
            <p:nvGrpSpPr>
              <p:cNvPr id="556" name="グループ化 555"/>
              <p:cNvGrpSpPr/>
              <p:nvPr/>
            </p:nvGrpSpPr>
            <p:grpSpPr>
              <a:xfrm>
                <a:off x="1155271" y="2754456"/>
                <a:ext cx="7446500" cy="963944"/>
                <a:chOff x="1155271" y="2754456"/>
                <a:chExt cx="7446500" cy="963944"/>
              </a:xfrm>
            </p:grpSpPr>
            <p:sp>
              <p:nvSpPr>
                <p:cNvPr id="558" name="乗算記号 557"/>
                <p:cNvSpPr/>
                <p:nvPr/>
              </p:nvSpPr>
              <p:spPr>
                <a:xfrm>
                  <a:off x="8457771" y="3510900"/>
                  <a:ext cx="144000" cy="144000"/>
                </a:xfrm>
                <a:prstGeom prst="mathMultiply">
                  <a:avLst>
                    <a:gd name="adj1" fmla="val 8080"/>
                  </a:avLst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559" name="乗算記号 558"/>
                <p:cNvSpPr/>
                <p:nvPr/>
              </p:nvSpPr>
              <p:spPr>
                <a:xfrm>
                  <a:off x="7414555" y="3136250"/>
                  <a:ext cx="144000" cy="144000"/>
                </a:xfrm>
                <a:prstGeom prst="mathMultiply">
                  <a:avLst>
                    <a:gd name="adj1" fmla="val 8080"/>
                  </a:avLst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560" name="乗算記号 559"/>
                <p:cNvSpPr/>
                <p:nvPr/>
              </p:nvSpPr>
              <p:spPr>
                <a:xfrm>
                  <a:off x="6371341" y="3574400"/>
                  <a:ext cx="144000" cy="144000"/>
                </a:xfrm>
                <a:prstGeom prst="mathMultiply">
                  <a:avLst>
                    <a:gd name="adj1" fmla="val 8080"/>
                  </a:avLst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561" name="乗算記号 560"/>
                <p:cNvSpPr/>
                <p:nvPr/>
              </p:nvSpPr>
              <p:spPr>
                <a:xfrm>
                  <a:off x="5328127" y="3053700"/>
                  <a:ext cx="144000" cy="144000"/>
                </a:xfrm>
                <a:prstGeom prst="mathMultiply">
                  <a:avLst>
                    <a:gd name="adj1" fmla="val 8080"/>
                  </a:avLst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562" name="乗算記号 561"/>
                <p:cNvSpPr/>
                <p:nvPr/>
              </p:nvSpPr>
              <p:spPr>
                <a:xfrm>
                  <a:off x="4284913" y="3354531"/>
                  <a:ext cx="144000" cy="144000"/>
                </a:xfrm>
                <a:prstGeom prst="mathMultiply">
                  <a:avLst>
                    <a:gd name="adj1" fmla="val 8080"/>
                  </a:avLst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563" name="乗算記号 562"/>
                <p:cNvSpPr/>
                <p:nvPr/>
              </p:nvSpPr>
              <p:spPr>
                <a:xfrm>
                  <a:off x="3241699" y="2754456"/>
                  <a:ext cx="144000" cy="144000"/>
                </a:xfrm>
                <a:prstGeom prst="mathMultiply">
                  <a:avLst>
                    <a:gd name="adj1" fmla="val 8080"/>
                  </a:avLst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564" name="乗算記号 563"/>
                <p:cNvSpPr/>
                <p:nvPr/>
              </p:nvSpPr>
              <p:spPr>
                <a:xfrm>
                  <a:off x="2198485" y="2863994"/>
                  <a:ext cx="144000" cy="144000"/>
                </a:xfrm>
                <a:prstGeom prst="mathMultiply">
                  <a:avLst>
                    <a:gd name="adj1" fmla="val 8080"/>
                  </a:avLst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565" name="乗算記号 564"/>
                <p:cNvSpPr/>
                <p:nvPr/>
              </p:nvSpPr>
              <p:spPr>
                <a:xfrm>
                  <a:off x="1155271" y="3571225"/>
                  <a:ext cx="144000" cy="144000"/>
                </a:xfrm>
                <a:prstGeom prst="mathMultiply">
                  <a:avLst>
                    <a:gd name="adj1" fmla="val 8080"/>
                  </a:avLst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557" name="フリーフォーム 556"/>
              <p:cNvSpPr/>
              <p:nvPr/>
            </p:nvSpPr>
            <p:spPr>
              <a:xfrm>
                <a:off x="1226820" y="2819400"/>
                <a:ext cx="7299960" cy="830580"/>
              </a:xfrm>
              <a:custGeom>
                <a:avLst/>
                <a:gdLst>
                  <a:gd name="connsiteX0" fmla="*/ 0 w 7299960"/>
                  <a:gd name="connsiteY0" fmla="*/ 822960 h 830580"/>
                  <a:gd name="connsiteX1" fmla="*/ 1036320 w 7299960"/>
                  <a:gd name="connsiteY1" fmla="*/ 114300 h 830580"/>
                  <a:gd name="connsiteX2" fmla="*/ 2087880 w 7299960"/>
                  <a:gd name="connsiteY2" fmla="*/ 0 h 830580"/>
                  <a:gd name="connsiteX3" fmla="*/ 3124200 w 7299960"/>
                  <a:gd name="connsiteY3" fmla="*/ 609600 h 830580"/>
                  <a:gd name="connsiteX4" fmla="*/ 4175760 w 7299960"/>
                  <a:gd name="connsiteY4" fmla="*/ 312420 h 830580"/>
                  <a:gd name="connsiteX5" fmla="*/ 5219700 w 7299960"/>
                  <a:gd name="connsiteY5" fmla="*/ 830580 h 830580"/>
                  <a:gd name="connsiteX6" fmla="*/ 6248400 w 7299960"/>
                  <a:gd name="connsiteY6" fmla="*/ 381000 h 830580"/>
                  <a:gd name="connsiteX7" fmla="*/ 7299960 w 7299960"/>
                  <a:gd name="connsiteY7" fmla="*/ 769620 h 83058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7299960" h="830580">
                    <a:moveTo>
                      <a:pt x="0" y="822960"/>
                    </a:moveTo>
                    <a:lnTo>
                      <a:pt x="1036320" y="114300"/>
                    </a:lnTo>
                    <a:lnTo>
                      <a:pt x="2087880" y="0"/>
                    </a:lnTo>
                    <a:lnTo>
                      <a:pt x="3124200" y="609600"/>
                    </a:lnTo>
                    <a:lnTo>
                      <a:pt x="4175760" y="312420"/>
                    </a:lnTo>
                    <a:lnTo>
                      <a:pt x="5219700" y="830580"/>
                    </a:lnTo>
                    <a:lnTo>
                      <a:pt x="6248400" y="381000"/>
                    </a:lnTo>
                    <a:lnTo>
                      <a:pt x="7299960" y="769620"/>
                    </a:lnTo>
                  </a:path>
                </a:pathLst>
              </a:custGeom>
              <a:noFill/>
              <a:ln w="19050">
                <a:solidFill>
                  <a:schemeClr val="tx1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</p:grpSp>
      <p:sp>
        <p:nvSpPr>
          <p:cNvPr id="277" name="テキスト ボックス 276"/>
          <p:cNvSpPr txBox="1"/>
          <p:nvPr/>
        </p:nvSpPr>
        <p:spPr>
          <a:xfrm>
            <a:off x="177517" y="410963"/>
            <a:ext cx="9059107" cy="307777"/>
          </a:xfrm>
          <a:prstGeom prst="rect">
            <a:avLst/>
          </a:prstGeom>
        </p:spPr>
        <p:txBody>
          <a:bodyPr vert="horz" wrap="square" lIns="0" tIns="0" rIns="0" bIns="0" rtlCol="0" anchor="t" anchorCtr="0">
            <a:spAutoFit/>
          </a:bodyPr>
          <a:lstStyle/>
          <a:p>
            <a:pPr marL="85725">
              <a:spcBef>
                <a:spcPct val="0"/>
              </a:spcBef>
            </a:pPr>
            <a:r>
              <a:rPr kumimoji="0" lang="en-US" altLang="ja-JP" sz="20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Supplementary Figure </a:t>
            </a:r>
            <a:r>
              <a:rPr kumimoji="0" lang="en-US" altLang="ja-JP" sz="2000" b="1" dirty="0" smtClean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</a:t>
            </a:r>
            <a:r>
              <a:rPr lang="en-US" altLang="ja-JP" sz="20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 </a:t>
            </a:r>
            <a:r>
              <a:rPr lang="ja-JP" altLang="en-US" sz="2000" dirty="0" smtClean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　</a:t>
            </a:r>
            <a:r>
              <a:rPr lang="en-US" altLang="ja-JP" sz="2000" dirty="0" smtClean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Change </a:t>
            </a:r>
            <a:r>
              <a:rPr lang="en-US" altLang="ja-JP" sz="20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in serum K</a:t>
            </a:r>
            <a:r>
              <a:rPr lang="en-US" altLang="ja-JP" sz="2000" baseline="300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+ </a:t>
            </a:r>
            <a:r>
              <a:rPr lang="en-US" altLang="ja-JP" sz="20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over time</a:t>
            </a:r>
            <a:endParaRPr kumimoji="0" lang="ja-JP" altLang="en-US" sz="2000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991675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129</TotalTime>
  <Words>35</Words>
  <Application>Microsoft Office PowerPoint</Application>
  <PresentationFormat>画面に合わせる (4:3)</PresentationFormat>
  <Paragraphs>20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Company>Reed Elsevi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Reed Elsevier</dc:creator>
  <cp:lastModifiedBy>Admin</cp:lastModifiedBy>
  <cp:revision>85</cp:revision>
  <cp:lastPrinted>2018-09-26T01:13:51Z</cp:lastPrinted>
  <dcterms:created xsi:type="dcterms:W3CDTF">2017-09-08T02:22:07Z</dcterms:created>
  <dcterms:modified xsi:type="dcterms:W3CDTF">2018-12-18T02:54:1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NXPowerLiteLastOptimized">
    <vt:lpwstr>614361</vt:lpwstr>
  </property>
  <property fmtid="{D5CDD505-2E9C-101B-9397-08002B2CF9AE}" pid="3" name="NXPowerLiteSettings">
    <vt:lpwstr>C7000400038000</vt:lpwstr>
  </property>
  <property fmtid="{D5CDD505-2E9C-101B-9397-08002B2CF9AE}" pid="4" name="NXPowerLiteVersion">
    <vt:lpwstr>D7.1.5</vt:lpwstr>
  </property>
</Properties>
</file>